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7"/>
  </p:notesMasterIdLst>
  <p:sldIdLst>
    <p:sldId id="667" r:id="rId2"/>
    <p:sldId id="672" r:id="rId3"/>
    <p:sldId id="678" r:id="rId4"/>
    <p:sldId id="670" r:id="rId5"/>
    <p:sldId id="679" r:id="rId6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65C0CD2B-D206-405E-876A-6BAEA104010B}" v="1" dt="2026-01-26T20:02:25.156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>
      <p:cViewPr varScale="1">
        <p:scale>
          <a:sx n="105" d="100"/>
          <a:sy n="105" d="100"/>
        </p:scale>
        <p:origin x="798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13" Type="http://schemas.microsoft.com/office/2015/10/relationships/revisionInfo" Target="revisionInfo.xml"/><Relationship Id="rId3" Type="http://schemas.openxmlformats.org/officeDocument/2006/relationships/slide" Target="slides/slide2.xml"/><Relationship Id="rId7" Type="http://schemas.openxmlformats.org/officeDocument/2006/relationships/notesMaster" Target="notesMasters/notesMaster1.xml"/><Relationship Id="rId12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Verma, Priyanka" userId="58b0ae7e-fb97-4d47-9a33-097085df7ead" providerId="ADAL" clId="{0D9F440F-CEC3-4D05-92E7-742190817FFE}"/>
    <pc:docChg chg="addSld modSld">
      <pc:chgData name="Verma, Priyanka" userId="58b0ae7e-fb97-4d47-9a33-097085df7ead" providerId="ADAL" clId="{0D9F440F-CEC3-4D05-92E7-742190817FFE}" dt="2026-01-26T20:02:25.141" v="0"/>
      <pc:docMkLst>
        <pc:docMk/>
      </pc:docMkLst>
      <pc:sldChg chg="add">
        <pc:chgData name="Verma, Priyanka" userId="58b0ae7e-fb97-4d47-9a33-097085df7ead" providerId="ADAL" clId="{0D9F440F-CEC3-4D05-92E7-742190817FFE}" dt="2026-01-26T20:02:25.141" v="0"/>
        <pc:sldMkLst>
          <pc:docMk/>
          <pc:sldMk cId="2971705216" sldId="667"/>
        </pc:sldMkLst>
      </pc:sldChg>
      <pc:sldChg chg="add">
        <pc:chgData name="Verma, Priyanka" userId="58b0ae7e-fb97-4d47-9a33-097085df7ead" providerId="ADAL" clId="{0D9F440F-CEC3-4D05-92E7-742190817FFE}" dt="2026-01-26T20:02:25.141" v="0"/>
        <pc:sldMkLst>
          <pc:docMk/>
          <pc:sldMk cId="1650944412" sldId="670"/>
        </pc:sldMkLst>
      </pc:sldChg>
      <pc:sldChg chg="add">
        <pc:chgData name="Verma, Priyanka" userId="58b0ae7e-fb97-4d47-9a33-097085df7ead" providerId="ADAL" clId="{0D9F440F-CEC3-4D05-92E7-742190817FFE}" dt="2026-01-26T20:02:25.141" v="0"/>
        <pc:sldMkLst>
          <pc:docMk/>
          <pc:sldMk cId="1101955366" sldId="672"/>
        </pc:sldMkLst>
      </pc:sldChg>
      <pc:sldChg chg="add">
        <pc:chgData name="Verma, Priyanka" userId="58b0ae7e-fb97-4d47-9a33-097085df7ead" providerId="ADAL" clId="{0D9F440F-CEC3-4D05-92E7-742190817FFE}" dt="2026-01-26T20:02:25.141" v="0"/>
        <pc:sldMkLst>
          <pc:docMk/>
          <pc:sldMk cId="4045285680" sldId="678"/>
        </pc:sldMkLst>
      </pc:sldChg>
      <pc:sldChg chg="add">
        <pc:chgData name="Verma, Priyanka" userId="58b0ae7e-fb97-4d47-9a33-097085df7ead" providerId="ADAL" clId="{0D9F440F-CEC3-4D05-92E7-742190817FFE}" dt="2026-01-26T20:02:25.141" v="0"/>
        <pc:sldMkLst>
          <pc:docMk/>
          <pc:sldMk cId="658382172" sldId="679"/>
        </pc:sldMkLst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6FB7321-219D-4A3D-99DF-5055AA177FDE}" type="datetimeFigureOut">
              <a:rPr lang="en-US" smtClean="0"/>
              <a:t>1/26/2026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8EFC09E-0DD6-43AF-8473-EDBDB1F42B9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1622854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55C97DF3-185E-4F37-A973-6DF79BA30FD7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1912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5FC2D63-3F5D-2290-3211-9849624B36CC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4748BB16-314C-452B-7092-B639298DA1BD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632C990-AF9C-1197-4A1F-0BB6A48564D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15254A-CD9D-430E-94CD-144E2EC0645E}" type="datetimeFigureOut">
              <a:rPr lang="en-US" smtClean="0"/>
              <a:t>1/26/20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67A0725-8FAE-4C2A-F05C-44C7298C1BE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CB56FCC-667D-A59B-FFCC-20691245F08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7760E8-47ED-47B5-B64F-EE92B8A292A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7859368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8231724-E579-19E0-1440-6E137B2751D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599777FE-1D91-72CA-D6C1-36B8DAF76D9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E450A74-A579-CF2E-B984-C471C642E2E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15254A-CD9D-430E-94CD-144E2EC0645E}" type="datetimeFigureOut">
              <a:rPr lang="en-US" smtClean="0"/>
              <a:t>1/26/20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E0008D4-6AFE-DB50-B1EC-1C1C39CFC8D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1F7420F-586C-6262-3E81-16C93C31E56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7760E8-47ED-47B5-B64F-EE92B8A292A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2401657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E404CDB5-5B91-FAA8-DBA3-77B3254A3224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524F65D9-768B-6AEE-5CF6-37CB788C39B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C3FBD92-380C-F7AC-CAB6-E3AA85472FB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15254A-CD9D-430E-94CD-144E2EC0645E}" type="datetimeFigureOut">
              <a:rPr lang="en-US" smtClean="0"/>
              <a:t>1/26/20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4066AC1-C315-8976-D81A-C95645FD2DD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EDE9777-C5CB-34EC-A585-A474CF0516F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7760E8-47ED-47B5-B64F-EE92B8A292A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6648156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E6A95F2-F609-6BE0-509E-31B807F6C83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9A4B843-2142-1695-2DD5-E15AECBE29E7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DA3EB47-9DB2-368D-2142-245E1427C72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15254A-CD9D-430E-94CD-144E2EC0645E}" type="datetimeFigureOut">
              <a:rPr lang="en-US" smtClean="0"/>
              <a:t>1/26/20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7C2D909-98F2-3A25-FEB1-075EBC22D01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F69F567-0770-D09F-7B88-C8AF050FBD9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7760E8-47ED-47B5-B64F-EE92B8A292A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4566974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21D0ED9-1324-297E-D3AA-95F64236924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73AB7B0-F9B9-B84C-A4BD-F448DAA672E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04A23AD-4F58-FFB7-F751-7D1FDE6C89D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15254A-CD9D-430E-94CD-144E2EC0645E}" type="datetimeFigureOut">
              <a:rPr lang="en-US" smtClean="0"/>
              <a:t>1/26/20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42BEE61-B03F-85F3-760A-4E3889794DC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50BFC84-0BB5-8676-1C59-37A664D78A9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7760E8-47ED-47B5-B64F-EE92B8A292A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8324093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4CD5DB1-2A14-626F-2BA2-DAE6DD268FE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EE823C0-6BF6-07D3-D618-BADDAD2C49FE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0886C437-9BC3-27F4-0216-3A16DC1EF61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A8C09FB-3D8B-4B95-68D3-BF08320A13F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15254A-CD9D-430E-94CD-144E2EC0645E}" type="datetimeFigureOut">
              <a:rPr lang="en-US" smtClean="0"/>
              <a:t>1/26/2026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8BB7642-5EBF-2507-8372-580E184D423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EF7321E-1EA6-D5CB-A67A-47539BE7A78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7760E8-47ED-47B5-B64F-EE92B8A292A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5667143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55E2114-C78F-3128-B7FC-9A5356FFB80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EDFA511-8A6D-4B1C-7447-A7C009CC169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C5B397E5-6347-700D-E022-6F5BC8EB491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87B1A0FD-C786-B185-989E-71B909C8AF21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50F129FC-87E6-92F1-FF68-34709529BEAE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9F86B693-DBFE-D25A-3A77-00F4BC71E7B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15254A-CD9D-430E-94CD-144E2EC0645E}" type="datetimeFigureOut">
              <a:rPr lang="en-US" smtClean="0"/>
              <a:t>1/26/2026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C83151EC-2112-D6CC-9B8E-BB9AB687456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23EBD2D9-F8F5-690E-13EA-3A2110CF73D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7760E8-47ED-47B5-B64F-EE92B8A292A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8946180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F48FEEC-E8C0-BCD1-65F7-2376EA04F41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BC9F288E-8419-2F8C-A5C7-205B6565348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15254A-CD9D-430E-94CD-144E2EC0645E}" type="datetimeFigureOut">
              <a:rPr lang="en-US" smtClean="0"/>
              <a:t>1/26/2026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2E47FEC2-FB86-48A6-F0EA-9FB79AD88DC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76D11656-B765-B19C-444A-6D1C0A4AC1C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7760E8-47ED-47B5-B64F-EE92B8A292A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6945528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6ACAF2D8-E215-D0EC-B6CB-D985150312F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15254A-CD9D-430E-94CD-144E2EC0645E}" type="datetimeFigureOut">
              <a:rPr lang="en-US" smtClean="0"/>
              <a:t>1/26/2026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EF2C2E5E-343D-E4F9-E0E8-F651C20770B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BCA00B34-7CD0-09C4-E7D3-A13B0542F67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7760E8-47ED-47B5-B64F-EE92B8A292A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7428748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C5CA691-C004-7BAD-2CE2-387D116E4E7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76905B7-4045-B75A-FB8D-1CAE93FB2945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76729A0A-0EEF-15BD-4776-BCF13B05F08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34FAD62-8E96-F157-10EC-5963CEF7B5C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15254A-CD9D-430E-94CD-144E2EC0645E}" type="datetimeFigureOut">
              <a:rPr lang="en-US" smtClean="0"/>
              <a:t>1/26/2026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1464DE15-9E39-A376-BBBE-E6260CE45D5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691CA81-CB83-EBAD-D67D-1AF0C07864E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7760E8-47ED-47B5-B64F-EE92B8A292A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6134065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32FD877-784C-2963-00AF-B6942496EB4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7224B47F-7F73-EB22-5B18-1C9AFF71EFAE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CF6347CA-EE46-8A07-51BD-0612571527B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861E0A2-3F9A-B884-ACFF-6D3E321C2D2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15254A-CD9D-430E-94CD-144E2EC0645E}" type="datetimeFigureOut">
              <a:rPr lang="en-US" smtClean="0"/>
              <a:t>1/26/2026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D427F2D-4C8B-8AFB-4B90-CAC721F82AD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6AD93A9-880E-F170-61DB-430B720E749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7760E8-47ED-47B5-B64F-EE92B8A292A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6364515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4EECBBE4-92D2-1DEE-9391-A563E81E636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C989341-F107-089C-AE19-551160A4A8A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D3D117C-6A8A-64EB-83DD-6453D3623A71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8615254A-CD9D-430E-94CD-144E2EC0645E}" type="datetimeFigureOut">
              <a:rPr lang="en-US" smtClean="0"/>
              <a:t>1/26/20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4325B4E-F08F-0055-0A26-E239FA2520FF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C2AD5D1-5A35-3CC0-A93E-0A5BF555D18A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E37760E8-47ED-47B5-B64F-EE92B8A292A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0716788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microsoft.com/office/2007/relationships/hdphoto" Target="../media/hdphoto2.wdp"/><Relationship Id="rId5" Type="http://schemas.openxmlformats.org/officeDocument/2006/relationships/image" Target="../media/image2.png"/><Relationship Id="rId4" Type="http://schemas.microsoft.com/office/2007/relationships/hdphoto" Target="../media/hdphoto1.wdp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png"/><Relationship Id="rId13" Type="http://schemas.microsoft.com/office/2007/relationships/hdphoto" Target="../media/hdphoto8.wdp"/><Relationship Id="rId3" Type="http://schemas.microsoft.com/office/2007/relationships/hdphoto" Target="../media/hdphoto3.wdp"/><Relationship Id="rId7" Type="http://schemas.microsoft.com/office/2007/relationships/hdphoto" Target="../media/hdphoto5.wdp"/><Relationship Id="rId12" Type="http://schemas.openxmlformats.org/officeDocument/2006/relationships/image" Target="../media/image8.png"/><Relationship Id="rId17" Type="http://schemas.openxmlformats.org/officeDocument/2006/relationships/image" Target="../media/image10.emf"/><Relationship Id="rId2" Type="http://schemas.openxmlformats.org/officeDocument/2006/relationships/image" Target="../media/image3.png"/><Relationship Id="rId16" Type="http://schemas.openxmlformats.org/officeDocument/2006/relationships/oleObject" Target="../embeddings/oleObject2.bin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11" Type="http://schemas.microsoft.com/office/2007/relationships/hdphoto" Target="../media/hdphoto7.wdp"/><Relationship Id="rId5" Type="http://schemas.microsoft.com/office/2007/relationships/hdphoto" Target="../media/hdphoto4.wdp"/><Relationship Id="rId15" Type="http://schemas.openxmlformats.org/officeDocument/2006/relationships/image" Target="../media/image9.emf"/><Relationship Id="rId10" Type="http://schemas.openxmlformats.org/officeDocument/2006/relationships/image" Target="../media/image7.png"/><Relationship Id="rId4" Type="http://schemas.openxmlformats.org/officeDocument/2006/relationships/image" Target="../media/image4.png"/><Relationship Id="rId9" Type="http://schemas.microsoft.com/office/2007/relationships/hdphoto" Target="../media/hdphoto6.wdp"/><Relationship Id="rId14" Type="http://schemas.openxmlformats.org/officeDocument/2006/relationships/oleObject" Target="../embeddings/oleObject1.bin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emf"/><Relationship Id="rId7" Type="http://schemas.openxmlformats.org/officeDocument/2006/relationships/image" Target="../media/image13.emf"/><Relationship Id="rId2" Type="http://schemas.openxmlformats.org/officeDocument/2006/relationships/oleObject" Target="../embeddings/oleObject3.bin"/><Relationship Id="rId1" Type="http://schemas.openxmlformats.org/officeDocument/2006/relationships/slideLayout" Target="../slideLayouts/slideLayout7.xml"/><Relationship Id="rId6" Type="http://schemas.openxmlformats.org/officeDocument/2006/relationships/oleObject" Target="../embeddings/oleObject5.bin"/><Relationship Id="rId5" Type="http://schemas.openxmlformats.org/officeDocument/2006/relationships/image" Target="../media/image12.emf"/><Relationship Id="rId4" Type="http://schemas.openxmlformats.org/officeDocument/2006/relationships/oleObject" Target="../embeddings/oleObject4.bin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emf"/><Relationship Id="rId2" Type="http://schemas.openxmlformats.org/officeDocument/2006/relationships/oleObject" Target="../embeddings/oleObject6.bin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5.emf"/><Relationship Id="rId2" Type="http://schemas.openxmlformats.org/officeDocument/2006/relationships/oleObject" Target="../embeddings/oleObject7.bin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7" name="Group 16">
            <a:extLst>
              <a:ext uri="{FF2B5EF4-FFF2-40B4-BE49-F238E27FC236}">
                <a16:creationId xmlns:a16="http://schemas.microsoft.com/office/drawing/2014/main" id="{F6F47A11-A960-9A6C-B6B0-869137217648}"/>
              </a:ext>
            </a:extLst>
          </p:cNvPr>
          <p:cNvGrpSpPr/>
          <p:nvPr/>
        </p:nvGrpSpPr>
        <p:grpSpPr>
          <a:xfrm>
            <a:off x="2347173" y="1968176"/>
            <a:ext cx="5769108" cy="2752691"/>
            <a:chOff x="1539764" y="1646486"/>
            <a:chExt cx="5769108" cy="2752691"/>
          </a:xfrm>
        </p:grpSpPr>
        <p:grpSp>
          <p:nvGrpSpPr>
            <p:cNvPr id="2" name="Group 1">
              <a:extLst>
                <a:ext uri="{FF2B5EF4-FFF2-40B4-BE49-F238E27FC236}">
                  <a16:creationId xmlns:a16="http://schemas.microsoft.com/office/drawing/2014/main" id="{A7F2F631-A34B-7F2E-2796-580B62E1A5CC}"/>
                </a:ext>
              </a:extLst>
            </p:cNvPr>
            <p:cNvGrpSpPr/>
            <p:nvPr/>
          </p:nvGrpSpPr>
          <p:grpSpPr>
            <a:xfrm>
              <a:off x="1539764" y="1646486"/>
              <a:ext cx="5769108" cy="2752691"/>
              <a:chOff x="1539764" y="1646486"/>
              <a:chExt cx="5769108" cy="2752691"/>
            </a:xfrm>
          </p:grpSpPr>
          <p:grpSp>
            <p:nvGrpSpPr>
              <p:cNvPr id="3" name="Group 2">
                <a:extLst>
                  <a:ext uri="{FF2B5EF4-FFF2-40B4-BE49-F238E27FC236}">
                    <a16:creationId xmlns:a16="http://schemas.microsoft.com/office/drawing/2014/main" id="{016873F3-C20B-04B6-9033-B962C8DB2B93}"/>
                  </a:ext>
                </a:extLst>
              </p:cNvPr>
              <p:cNvGrpSpPr/>
              <p:nvPr/>
            </p:nvGrpSpPr>
            <p:grpSpPr>
              <a:xfrm>
                <a:off x="1801558" y="1646486"/>
                <a:ext cx="5507314" cy="2752691"/>
                <a:chOff x="1801558" y="1646486"/>
                <a:chExt cx="5507314" cy="2752691"/>
              </a:xfrm>
            </p:grpSpPr>
            <p:pic>
              <p:nvPicPr>
                <p:cNvPr id="6" name="Picture 5" descr="A microscope image of cells&#10;&#10;Description automatically generated">
                  <a:extLst>
                    <a:ext uri="{FF2B5EF4-FFF2-40B4-BE49-F238E27FC236}">
                      <a16:creationId xmlns:a16="http://schemas.microsoft.com/office/drawing/2014/main" id="{C9F9618C-0590-70CE-255E-D291C7223348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3">
                  <a:extLst>
                    <a:ext uri="{BEBA8EAE-BF5A-486C-A8C5-ECC9F3942E4B}">
                      <a14:imgProps xmlns:a14="http://schemas.microsoft.com/office/drawing/2010/main">
                        <a14:imgLayer r:embed="rId4">
                          <a14:imgEffect>
                            <a14:brightnessContrast bright="40000" contrast="40000"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 rot="16200000">
                  <a:off x="4565672" y="1655977"/>
                  <a:ext cx="2743200" cy="2743200"/>
                </a:xfrm>
                <a:prstGeom prst="rect">
                  <a:avLst/>
                </a:prstGeom>
              </p:spPr>
            </p:pic>
            <p:pic>
              <p:nvPicPr>
                <p:cNvPr id="7" name="Picture 6" descr="A screenshot of a cell&#10;&#10;Description automatically generated">
                  <a:extLst>
                    <a:ext uri="{FF2B5EF4-FFF2-40B4-BE49-F238E27FC236}">
                      <a16:creationId xmlns:a16="http://schemas.microsoft.com/office/drawing/2014/main" id="{7D3FBF20-C80A-4278-0C94-C2D31BFD02A9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5">
                  <a:extLst>
                    <a:ext uri="{BEBA8EAE-BF5A-486C-A8C5-ECC9F3942E4B}">
                      <a14:imgProps xmlns:a14="http://schemas.microsoft.com/office/drawing/2010/main">
                        <a14:imgLayer r:embed="rId6">
                          <a14:imgEffect>
                            <a14:brightnessContrast bright="40000" contrast="40000"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 rot="16200000">
                  <a:off x="1801558" y="1646486"/>
                  <a:ext cx="2743200" cy="2743200"/>
                </a:xfrm>
                <a:prstGeom prst="rect">
                  <a:avLst/>
                </a:prstGeom>
              </p:spPr>
            </p:pic>
            <p:sp>
              <p:nvSpPr>
                <p:cNvPr id="8" name="Freeform: Shape 7">
                  <a:extLst>
                    <a:ext uri="{FF2B5EF4-FFF2-40B4-BE49-F238E27FC236}">
                      <a16:creationId xmlns:a16="http://schemas.microsoft.com/office/drawing/2014/main" id="{63331610-6114-F16E-8C3A-DB5F9E293263}"/>
                    </a:ext>
                  </a:extLst>
                </p:cNvPr>
                <p:cNvSpPr/>
                <p:nvPr/>
              </p:nvSpPr>
              <p:spPr>
                <a:xfrm>
                  <a:off x="1847088" y="1938528"/>
                  <a:ext cx="2706632" cy="868680"/>
                </a:xfrm>
                <a:custGeom>
                  <a:avLst/>
                  <a:gdLst>
                    <a:gd name="connsiteX0" fmla="*/ 0 w 2706632"/>
                    <a:gd name="connsiteY0" fmla="*/ 301752 h 868680"/>
                    <a:gd name="connsiteX1" fmla="*/ 265176 w 2706632"/>
                    <a:gd name="connsiteY1" fmla="*/ 146304 h 868680"/>
                    <a:gd name="connsiteX2" fmla="*/ 374904 w 2706632"/>
                    <a:gd name="connsiteY2" fmla="*/ 73152 h 868680"/>
                    <a:gd name="connsiteX3" fmla="*/ 457200 w 2706632"/>
                    <a:gd name="connsiteY3" fmla="*/ 27432 h 868680"/>
                    <a:gd name="connsiteX4" fmla="*/ 484632 w 2706632"/>
                    <a:gd name="connsiteY4" fmla="*/ 0 h 868680"/>
                    <a:gd name="connsiteX5" fmla="*/ 731520 w 2706632"/>
                    <a:gd name="connsiteY5" fmla="*/ 36576 h 868680"/>
                    <a:gd name="connsiteX6" fmla="*/ 777240 w 2706632"/>
                    <a:gd name="connsiteY6" fmla="*/ 45720 h 868680"/>
                    <a:gd name="connsiteX7" fmla="*/ 868680 w 2706632"/>
                    <a:gd name="connsiteY7" fmla="*/ 91440 h 868680"/>
                    <a:gd name="connsiteX8" fmla="*/ 896112 w 2706632"/>
                    <a:gd name="connsiteY8" fmla="*/ 109728 h 868680"/>
                    <a:gd name="connsiteX9" fmla="*/ 978408 w 2706632"/>
                    <a:gd name="connsiteY9" fmla="*/ 137160 h 868680"/>
                    <a:gd name="connsiteX10" fmla="*/ 1060704 w 2706632"/>
                    <a:gd name="connsiteY10" fmla="*/ 164592 h 868680"/>
                    <a:gd name="connsiteX11" fmla="*/ 1097280 w 2706632"/>
                    <a:gd name="connsiteY11" fmla="*/ 182880 h 868680"/>
                    <a:gd name="connsiteX12" fmla="*/ 1161288 w 2706632"/>
                    <a:gd name="connsiteY12" fmla="*/ 201168 h 868680"/>
                    <a:gd name="connsiteX13" fmla="*/ 1243584 w 2706632"/>
                    <a:gd name="connsiteY13" fmla="*/ 219456 h 868680"/>
                    <a:gd name="connsiteX14" fmla="*/ 1298448 w 2706632"/>
                    <a:gd name="connsiteY14" fmla="*/ 274320 h 868680"/>
                    <a:gd name="connsiteX15" fmla="*/ 1335024 w 2706632"/>
                    <a:gd name="connsiteY15" fmla="*/ 292608 h 868680"/>
                    <a:gd name="connsiteX16" fmla="*/ 1399032 w 2706632"/>
                    <a:gd name="connsiteY16" fmla="*/ 329184 h 868680"/>
                    <a:gd name="connsiteX17" fmla="*/ 1417320 w 2706632"/>
                    <a:gd name="connsiteY17" fmla="*/ 356616 h 868680"/>
                    <a:gd name="connsiteX18" fmla="*/ 1453896 w 2706632"/>
                    <a:gd name="connsiteY18" fmla="*/ 365760 h 868680"/>
                    <a:gd name="connsiteX19" fmla="*/ 1627632 w 2706632"/>
                    <a:gd name="connsiteY19" fmla="*/ 384048 h 868680"/>
                    <a:gd name="connsiteX20" fmla="*/ 1664208 w 2706632"/>
                    <a:gd name="connsiteY20" fmla="*/ 438912 h 868680"/>
                    <a:gd name="connsiteX21" fmla="*/ 1737360 w 2706632"/>
                    <a:gd name="connsiteY21" fmla="*/ 502920 h 868680"/>
                    <a:gd name="connsiteX22" fmla="*/ 1773936 w 2706632"/>
                    <a:gd name="connsiteY22" fmla="*/ 521208 h 868680"/>
                    <a:gd name="connsiteX23" fmla="*/ 1828800 w 2706632"/>
                    <a:gd name="connsiteY23" fmla="*/ 557784 h 868680"/>
                    <a:gd name="connsiteX24" fmla="*/ 1874520 w 2706632"/>
                    <a:gd name="connsiteY24" fmla="*/ 566928 h 868680"/>
                    <a:gd name="connsiteX25" fmla="*/ 1956816 w 2706632"/>
                    <a:gd name="connsiteY25" fmla="*/ 594360 h 868680"/>
                    <a:gd name="connsiteX26" fmla="*/ 2194560 w 2706632"/>
                    <a:gd name="connsiteY26" fmla="*/ 630936 h 868680"/>
                    <a:gd name="connsiteX27" fmla="*/ 2295144 w 2706632"/>
                    <a:gd name="connsiteY27" fmla="*/ 649224 h 868680"/>
                    <a:gd name="connsiteX28" fmla="*/ 2441448 w 2706632"/>
                    <a:gd name="connsiteY28" fmla="*/ 694944 h 868680"/>
                    <a:gd name="connsiteX29" fmla="*/ 2560320 w 2706632"/>
                    <a:gd name="connsiteY29" fmla="*/ 704088 h 868680"/>
                    <a:gd name="connsiteX30" fmla="*/ 2642616 w 2706632"/>
                    <a:gd name="connsiteY30" fmla="*/ 795528 h 868680"/>
                    <a:gd name="connsiteX31" fmla="*/ 2706624 w 2706632"/>
                    <a:gd name="connsiteY31" fmla="*/ 868680 h 86868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  <a:cxn ang="0">
                      <a:pos x="connsiteX5" y="connsiteY5"/>
                    </a:cxn>
                    <a:cxn ang="0">
                      <a:pos x="connsiteX6" y="connsiteY6"/>
                    </a:cxn>
                    <a:cxn ang="0">
                      <a:pos x="connsiteX7" y="connsiteY7"/>
                    </a:cxn>
                    <a:cxn ang="0">
                      <a:pos x="connsiteX8" y="connsiteY8"/>
                    </a:cxn>
                    <a:cxn ang="0">
                      <a:pos x="connsiteX9" y="connsiteY9"/>
                    </a:cxn>
                    <a:cxn ang="0">
                      <a:pos x="connsiteX10" y="connsiteY10"/>
                    </a:cxn>
                    <a:cxn ang="0">
                      <a:pos x="connsiteX11" y="connsiteY11"/>
                    </a:cxn>
                    <a:cxn ang="0">
                      <a:pos x="connsiteX12" y="connsiteY12"/>
                    </a:cxn>
                    <a:cxn ang="0">
                      <a:pos x="connsiteX13" y="connsiteY13"/>
                    </a:cxn>
                    <a:cxn ang="0">
                      <a:pos x="connsiteX14" y="connsiteY14"/>
                    </a:cxn>
                    <a:cxn ang="0">
                      <a:pos x="connsiteX15" y="connsiteY15"/>
                    </a:cxn>
                    <a:cxn ang="0">
                      <a:pos x="connsiteX16" y="connsiteY16"/>
                    </a:cxn>
                    <a:cxn ang="0">
                      <a:pos x="connsiteX17" y="connsiteY17"/>
                    </a:cxn>
                    <a:cxn ang="0">
                      <a:pos x="connsiteX18" y="connsiteY18"/>
                    </a:cxn>
                    <a:cxn ang="0">
                      <a:pos x="connsiteX19" y="connsiteY19"/>
                    </a:cxn>
                    <a:cxn ang="0">
                      <a:pos x="connsiteX20" y="connsiteY20"/>
                    </a:cxn>
                    <a:cxn ang="0">
                      <a:pos x="connsiteX21" y="connsiteY21"/>
                    </a:cxn>
                    <a:cxn ang="0">
                      <a:pos x="connsiteX22" y="connsiteY22"/>
                    </a:cxn>
                    <a:cxn ang="0">
                      <a:pos x="connsiteX23" y="connsiteY23"/>
                    </a:cxn>
                    <a:cxn ang="0">
                      <a:pos x="connsiteX24" y="connsiteY24"/>
                    </a:cxn>
                    <a:cxn ang="0">
                      <a:pos x="connsiteX25" y="connsiteY25"/>
                    </a:cxn>
                    <a:cxn ang="0">
                      <a:pos x="connsiteX26" y="connsiteY26"/>
                    </a:cxn>
                    <a:cxn ang="0">
                      <a:pos x="connsiteX27" y="connsiteY27"/>
                    </a:cxn>
                    <a:cxn ang="0">
                      <a:pos x="connsiteX28" y="connsiteY28"/>
                    </a:cxn>
                    <a:cxn ang="0">
                      <a:pos x="connsiteX29" y="connsiteY29"/>
                    </a:cxn>
                    <a:cxn ang="0">
                      <a:pos x="connsiteX30" y="connsiteY30"/>
                    </a:cxn>
                    <a:cxn ang="0">
                      <a:pos x="connsiteX31" y="connsiteY31"/>
                    </a:cxn>
                  </a:cxnLst>
                  <a:rect l="l" t="t" r="r" b="b"/>
                  <a:pathLst>
                    <a:path w="2706632" h="868680">
                      <a:moveTo>
                        <a:pt x="0" y="301752"/>
                      </a:moveTo>
                      <a:cubicBezTo>
                        <a:pt x="121358" y="204665"/>
                        <a:pt x="-16944" y="310874"/>
                        <a:pt x="265176" y="146304"/>
                      </a:cubicBezTo>
                      <a:cubicBezTo>
                        <a:pt x="303147" y="124154"/>
                        <a:pt x="335586" y="92811"/>
                        <a:pt x="374904" y="73152"/>
                      </a:cubicBezTo>
                      <a:cubicBezTo>
                        <a:pt x="400958" y="60125"/>
                        <a:pt x="434237" y="44655"/>
                        <a:pt x="457200" y="27432"/>
                      </a:cubicBezTo>
                      <a:cubicBezTo>
                        <a:pt x="467545" y="19673"/>
                        <a:pt x="475488" y="9144"/>
                        <a:pt x="484632" y="0"/>
                      </a:cubicBezTo>
                      <a:lnTo>
                        <a:pt x="731520" y="36576"/>
                      </a:lnTo>
                      <a:cubicBezTo>
                        <a:pt x="746875" y="38975"/>
                        <a:pt x="762810" y="39948"/>
                        <a:pt x="777240" y="45720"/>
                      </a:cubicBezTo>
                      <a:cubicBezTo>
                        <a:pt x="808880" y="58376"/>
                        <a:pt x="838676" y="75284"/>
                        <a:pt x="868680" y="91440"/>
                      </a:cubicBezTo>
                      <a:cubicBezTo>
                        <a:pt x="878356" y="96650"/>
                        <a:pt x="885968" y="105501"/>
                        <a:pt x="896112" y="109728"/>
                      </a:cubicBezTo>
                      <a:cubicBezTo>
                        <a:pt x="922804" y="120849"/>
                        <a:pt x="951420" y="126780"/>
                        <a:pt x="978408" y="137160"/>
                      </a:cubicBezTo>
                      <a:cubicBezTo>
                        <a:pt x="1060433" y="168708"/>
                        <a:pt x="965647" y="145581"/>
                        <a:pt x="1060704" y="164592"/>
                      </a:cubicBezTo>
                      <a:cubicBezTo>
                        <a:pt x="1072896" y="170688"/>
                        <a:pt x="1084470" y="178222"/>
                        <a:pt x="1097280" y="182880"/>
                      </a:cubicBezTo>
                      <a:cubicBezTo>
                        <a:pt x="1118134" y="190463"/>
                        <a:pt x="1139880" y="195329"/>
                        <a:pt x="1161288" y="201168"/>
                      </a:cubicBezTo>
                      <a:cubicBezTo>
                        <a:pt x="1196800" y="210853"/>
                        <a:pt x="1205503" y="211840"/>
                        <a:pt x="1243584" y="219456"/>
                      </a:cubicBezTo>
                      <a:cubicBezTo>
                        <a:pt x="1345037" y="287092"/>
                        <a:pt x="1179358" y="172243"/>
                        <a:pt x="1298448" y="274320"/>
                      </a:cubicBezTo>
                      <a:cubicBezTo>
                        <a:pt x="1308797" y="283191"/>
                        <a:pt x="1323465" y="285384"/>
                        <a:pt x="1335024" y="292608"/>
                      </a:cubicBezTo>
                      <a:cubicBezTo>
                        <a:pt x="1398291" y="332150"/>
                        <a:pt x="1345138" y="311219"/>
                        <a:pt x="1399032" y="329184"/>
                      </a:cubicBezTo>
                      <a:cubicBezTo>
                        <a:pt x="1405128" y="338328"/>
                        <a:pt x="1408176" y="350520"/>
                        <a:pt x="1417320" y="356616"/>
                      </a:cubicBezTo>
                      <a:cubicBezTo>
                        <a:pt x="1427777" y="363587"/>
                        <a:pt x="1441531" y="363512"/>
                        <a:pt x="1453896" y="365760"/>
                      </a:cubicBezTo>
                      <a:cubicBezTo>
                        <a:pt x="1514542" y="376787"/>
                        <a:pt x="1564025" y="378747"/>
                        <a:pt x="1627632" y="384048"/>
                      </a:cubicBezTo>
                      <a:cubicBezTo>
                        <a:pt x="1639824" y="402336"/>
                        <a:pt x="1650714" y="421562"/>
                        <a:pt x="1664208" y="438912"/>
                      </a:cubicBezTo>
                      <a:cubicBezTo>
                        <a:pt x="1678444" y="457216"/>
                        <a:pt x="1722286" y="492870"/>
                        <a:pt x="1737360" y="502920"/>
                      </a:cubicBezTo>
                      <a:cubicBezTo>
                        <a:pt x="1748702" y="510481"/>
                        <a:pt x="1762247" y="514195"/>
                        <a:pt x="1773936" y="521208"/>
                      </a:cubicBezTo>
                      <a:cubicBezTo>
                        <a:pt x="1792783" y="532516"/>
                        <a:pt x="1807247" y="553473"/>
                        <a:pt x="1828800" y="557784"/>
                      </a:cubicBezTo>
                      <a:cubicBezTo>
                        <a:pt x="1844040" y="560832"/>
                        <a:pt x="1859576" y="562658"/>
                        <a:pt x="1874520" y="566928"/>
                      </a:cubicBezTo>
                      <a:cubicBezTo>
                        <a:pt x="1902323" y="574872"/>
                        <a:pt x="1928462" y="588689"/>
                        <a:pt x="1956816" y="594360"/>
                      </a:cubicBezTo>
                      <a:cubicBezTo>
                        <a:pt x="2146466" y="632290"/>
                        <a:pt x="1938329" y="592976"/>
                        <a:pt x="2194560" y="630936"/>
                      </a:cubicBezTo>
                      <a:cubicBezTo>
                        <a:pt x="2228270" y="635930"/>
                        <a:pt x="2262157" y="640672"/>
                        <a:pt x="2295144" y="649224"/>
                      </a:cubicBezTo>
                      <a:cubicBezTo>
                        <a:pt x="2344603" y="662047"/>
                        <a:pt x="2390505" y="691025"/>
                        <a:pt x="2441448" y="694944"/>
                      </a:cubicBezTo>
                      <a:lnTo>
                        <a:pt x="2560320" y="704088"/>
                      </a:lnTo>
                      <a:cubicBezTo>
                        <a:pt x="2578134" y="775343"/>
                        <a:pt x="2556312" y="720731"/>
                        <a:pt x="2642616" y="795528"/>
                      </a:cubicBezTo>
                      <a:cubicBezTo>
                        <a:pt x="2708779" y="852869"/>
                        <a:pt x="2706624" y="830253"/>
                        <a:pt x="2706624" y="868680"/>
                      </a:cubicBezTo>
                    </a:path>
                  </a:pathLst>
                </a:custGeom>
                <a:noFill/>
                <a:ln>
                  <a:solidFill>
                    <a:schemeClr val="bg1"/>
                  </a:solidFill>
                  <a:prstDash val="dash"/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9" name="Freeform: Shape 8">
                  <a:extLst>
                    <a:ext uri="{FF2B5EF4-FFF2-40B4-BE49-F238E27FC236}">
                      <a16:creationId xmlns:a16="http://schemas.microsoft.com/office/drawing/2014/main" id="{9F600E87-4668-7CD5-0767-FFC775D3E58B}"/>
                    </a:ext>
                  </a:extLst>
                </p:cNvPr>
                <p:cNvSpPr/>
                <p:nvPr/>
              </p:nvSpPr>
              <p:spPr>
                <a:xfrm>
                  <a:off x="6108192" y="1746504"/>
                  <a:ext cx="1188720" cy="1675596"/>
                </a:xfrm>
                <a:custGeom>
                  <a:avLst/>
                  <a:gdLst>
                    <a:gd name="connsiteX0" fmla="*/ 0 w 1188720"/>
                    <a:gd name="connsiteY0" fmla="*/ 0 h 1675596"/>
                    <a:gd name="connsiteX1" fmla="*/ 36576 w 1188720"/>
                    <a:gd name="connsiteY1" fmla="*/ 45720 h 1675596"/>
                    <a:gd name="connsiteX2" fmla="*/ 64008 w 1188720"/>
                    <a:gd name="connsiteY2" fmla="*/ 91440 h 1675596"/>
                    <a:gd name="connsiteX3" fmla="*/ 128016 w 1188720"/>
                    <a:gd name="connsiteY3" fmla="*/ 128016 h 1675596"/>
                    <a:gd name="connsiteX4" fmla="*/ 457200 w 1188720"/>
                    <a:gd name="connsiteY4" fmla="*/ 173736 h 1675596"/>
                    <a:gd name="connsiteX5" fmla="*/ 521208 w 1188720"/>
                    <a:gd name="connsiteY5" fmla="*/ 274320 h 1675596"/>
                    <a:gd name="connsiteX6" fmla="*/ 612648 w 1188720"/>
                    <a:gd name="connsiteY6" fmla="*/ 438912 h 1675596"/>
                    <a:gd name="connsiteX7" fmla="*/ 704088 w 1188720"/>
                    <a:gd name="connsiteY7" fmla="*/ 448056 h 1675596"/>
                    <a:gd name="connsiteX8" fmla="*/ 694944 w 1188720"/>
                    <a:gd name="connsiteY8" fmla="*/ 484632 h 1675596"/>
                    <a:gd name="connsiteX9" fmla="*/ 667512 w 1188720"/>
                    <a:gd name="connsiteY9" fmla="*/ 493776 h 1675596"/>
                    <a:gd name="connsiteX10" fmla="*/ 585216 w 1188720"/>
                    <a:gd name="connsiteY10" fmla="*/ 557784 h 1675596"/>
                    <a:gd name="connsiteX11" fmla="*/ 576072 w 1188720"/>
                    <a:gd name="connsiteY11" fmla="*/ 594360 h 1675596"/>
                    <a:gd name="connsiteX12" fmla="*/ 557784 w 1188720"/>
                    <a:gd name="connsiteY12" fmla="*/ 640080 h 1675596"/>
                    <a:gd name="connsiteX13" fmla="*/ 566928 w 1188720"/>
                    <a:gd name="connsiteY13" fmla="*/ 722376 h 1675596"/>
                    <a:gd name="connsiteX14" fmla="*/ 658368 w 1188720"/>
                    <a:gd name="connsiteY14" fmla="*/ 813816 h 1675596"/>
                    <a:gd name="connsiteX15" fmla="*/ 777240 w 1188720"/>
                    <a:gd name="connsiteY15" fmla="*/ 822960 h 1675596"/>
                    <a:gd name="connsiteX16" fmla="*/ 850392 w 1188720"/>
                    <a:gd name="connsiteY16" fmla="*/ 841248 h 1675596"/>
                    <a:gd name="connsiteX17" fmla="*/ 914400 w 1188720"/>
                    <a:gd name="connsiteY17" fmla="*/ 923544 h 1675596"/>
                    <a:gd name="connsiteX18" fmla="*/ 896112 w 1188720"/>
                    <a:gd name="connsiteY18" fmla="*/ 1124712 h 1675596"/>
                    <a:gd name="connsiteX19" fmla="*/ 877824 w 1188720"/>
                    <a:gd name="connsiteY19" fmla="*/ 1161288 h 1675596"/>
                    <a:gd name="connsiteX20" fmla="*/ 868680 w 1188720"/>
                    <a:gd name="connsiteY20" fmla="*/ 1207008 h 1675596"/>
                    <a:gd name="connsiteX21" fmla="*/ 896112 w 1188720"/>
                    <a:gd name="connsiteY21" fmla="*/ 1252728 h 1675596"/>
                    <a:gd name="connsiteX22" fmla="*/ 914400 w 1188720"/>
                    <a:gd name="connsiteY22" fmla="*/ 1280160 h 1675596"/>
                    <a:gd name="connsiteX23" fmla="*/ 960120 w 1188720"/>
                    <a:gd name="connsiteY23" fmla="*/ 1289304 h 1675596"/>
                    <a:gd name="connsiteX24" fmla="*/ 1060704 w 1188720"/>
                    <a:gd name="connsiteY24" fmla="*/ 1307592 h 1675596"/>
                    <a:gd name="connsiteX25" fmla="*/ 1097280 w 1188720"/>
                    <a:gd name="connsiteY25" fmla="*/ 1344168 h 1675596"/>
                    <a:gd name="connsiteX26" fmla="*/ 1069848 w 1188720"/>
                    <a:gd name="connsiteY26" fmla="*/ 1380744 h 1675596"/>
                    <a:gd name="connsiteX27" fmla="*/ 1014984 w 1188720"/>
                    <a:gd name="connsiteY27" fmla="*/ 1408176 h 1675596"/>
                    <a:gd name="connsiteX28" fmla="*/ 996696 w 1188720"/>
                    <a:gd name="connsiteY28" fmla="*/ 1435608 h 1675596"/>
                    <a:gd name="connsiteX29" fmla="*/ 950976 w 1188720"/>
                    <a:gd name="connsiteY29" fmla="*/ 1490472 h 1675596"/>
                    <a:gd name="connsiteX30" fmla="*/ 987552 w 1188720"/>
                    <a:gd name="connsiteY30" fmla="*/ 1636776 h 1675596"/>
                    <a:gd name="connsiteX31" fmla="*/ 1024128 w 1188720"/>
                    <a:gd name="connsiteY31" fmla="*/ 1655064 h 1675596"/>
                    <a:gd name="connsiteX32" fmla="*/ 1051560 w 1188720"/>
                    <a:gd name="connsiteY32" fmla="*/ 1673352 h 1675596"/>
                    <a:gd name="connsiteX33" fmla="*/ 1188720 w 1188720"/>
                    <a:gd name="connsiteY33" fmla="*/ 1673352 h 1675596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  <a:cxn ang="0">
                      <a:pos x="connsiteX5" y="connsiteY5"/>
                    </a:cxn>
                    <a:cxn ang="0">
                      <a:pos x="connsiteX6" y="connsiteY6"/>
                    </a:cxn>
                    <a:cxn ang="0">
                      <a:pos x="connsiteX7" y="connsiteY7"/>
                    </a:cxn>
                    <a:cxn ang="0">
                      <a:pos x="connsiteX8" y="connsiteY8"/>
                    </a:cxn>
                    <a:cxn ang="0">
                      <a:pos x="connsiteX9" y="connsiteY9"/>
                    </a:cxn>
                    <a:cxn ang="0">
                      <a:pos x="connsiteX10" y="connsiteY10"/>
                    </a:cxn>
                    <a:cxn ang="0">
                      <a:pos x="connsiteX11" y="connsiteY11"/>
                    </a:cxn>
                    <a:cxn ang="0">
                      <a:pos x="connsiteX12" y="connsiteY12"/>
                    </a:cxn>
                    <a:cxn ang="0">
                      <a:pos x="connsiteX13" y="connsiteY13"/>
                    </a:cxn>
                    <a:cxn ang="0">
                      <a:pos x="connsiteX14" y="connsiteY14"/>
                    </a:cxn>
                    <a:cxn ang="0">
                      <a:pos x="connsiteX15" y="connsiteY15"/>
                    </a:cxn>
                    <a:cxn ang="0">
                      <a:pos x="connsiteX16" y="connsiteY16"/>
                    </a:cxn>
                    <a:cxn ang="0">
                      <a:pos x="connsiteX17" y="connsiteY17"/>
                    </a:cxn>
                    <a:cxn ang="0">
                      <a:pos x="connsiteX18" y="connsiteY18"/>
                    </a:cxn>
                    <a:cxn ang="0">
                      <a:pos x="connsiteX19" y="connsiteY19"/>
                    </a:cxn>
                    <a:cxn ang="0">
                      <a:pos x="connsiteX20" y="connsiteY20"/>
                    </a:cxn>
                    <a:cxn ang="0">
                      <a:pos x="connsiteX21" y="connsiteY21"/>
                    </a:cxn>
                    <a:cxn ang="0">
                      <a:pos x="connsiteX22" y="connsiteY22"/>
                    </a:cxn>
                    <a:cxn ang="0">
                      <a:pos x="connsiteX23" y="connsiteY23"/>
                    </a:cxn>
                    <a:cxn ang="0">
                      <a:pos x="connsiteX24" y="connsiteY24"/>
                    </a:cxn>
                    <a:cxn ang="0">
                      <a:pos x="connsiteX25" y="connsiteY25"/>
                    </a:cxn>
                    <a:cxn ang="0">
                      <a:pos x="connsiteX26" y="connsiteY26"/>
                    </a:cxn>
                    <a:cxn ang="0">
                      <a:pos x="connsiteX27" y="connsiteY27"/>
                    </a:cxn>
                    <a:cxn ang="0">
                      <a:pos x="connsiteX28" y="connsiteY28"/>
                    </a:cxn>
                    <a:cxn ang="0">
                      <a:pos x="connsiteX29" y="connsiteY29"/>
                    </a:cxn>
                    <a:cxn ang="0">
                      <a:pos x="connsiteX30" y="connsiteY30"/>
                    </a:cxn>
                    <a:cxn ang="0">
                      <a:pos x="connsiteX31" y="connsiteY31"/>
                    </a:cxn>
                    <a:cxn ang="0">
                      <a:pos x="connsiteX32" y="connsiteY32"/>
                    </a:cxn>
                    <a:cxn ang="0">
                      <a:pos x="connsiteX33" y="connsiteY33"/>
                    </a:cxn>
                  </a:cxnLst>
                  <a:rect l="l" t="t" r="r" b="b"/>
                  <a:pathLst>
                    <a:path w="1188720" h="1675596">
                      <a:moveTo>
                        <a:pt x="0" y="0"/>
                      </a:moveTo>
                      <a:cubicBezTo>
                        <a:pt x="12192" y="15240"/>
                        <a:pt x="25384" y="29731"/>
                        <a:pt x="36576" y="45720"/>
                      </a:cubicBezTo>
                      <a:cubicBezTo>
                        <a:pt x="46768" y="60280"/>
                        <a:pt x="52442" y="77946"/>
                        <a:pt x="64008" y="91440"/>
                      </a:cubicBezTo>
                      <a:cubicBezTo>
                        <a:pt x="72615" y="101481"/>
                        <a:pt x="119028" y="124421"/>
                        <a:pt x="128016" y="128016"/>
                      </a:cubicBezTo>
                      <a:cubicBezTo>
                        <a:pt x="238495" y="172208"/>
                        <a:pt x="314173" y="159433"/>
                        <a:pt x="457200" y="173736"/>
                      </a:cubicBezTo>
                      <a:cubicBezTo>
                        <a:pt x="478536" y="207264"/>
                        <a:pt x="508641" y="236618"/>
                        <a:pt x="521208" y="274320"/>
                      </a:cubicBezTo>
                      <a:cubicBezTo>
                        <a:pt x="584661" y="464679"/>
                        <a:pt x="478594" y="458063"/>
                        <a:pt x="612648" y="438912"/>
                      </a:cubicBezTo>
                      <a:cubicBezTo>
                        <a:pt x="643128" y="441960"/>
                        <a:pt x="677311" y="433180"/>
                        <a:pt x="704088" y="448056"/>
                      </a:cubicBezTo>
                      <a:cubicBezTo>
                        <a:pt x="715074" y="454159"/>
                        <a:pt x="702795" y="474819"/>
                        <a:pt x="694944" y="484632"/>
                      </a:cubicBezTo>
                      <a:cubicBezTo>
                        <a:pt x="688923" y="492158"/>
                        <a:pt x="675938" y="489095"/>
                        <a:pt x="667512" y="493776"/>
                      </a:cubicBezTo>
                      <a:cubicBezTo>
                        <a:pt x="618294" y="521119"/>
                        <a:pt x="618537" y="524463"/>
                        <a:pt x="585216" y="557784"/>
                      </a:cubicBezTo>
                      <a:cubicBezTo>
                        <a:pt x="582168" y="569976"/>
                        <a:pt x="580046" y="582438"/>
                        <a:pt x="576072" y="594360"/>
                      </a:cubicBezTo>
                      <a:cubicBezTo>
                        <a:pt x="570881" y="609932"/>
                        <a:pt x="558953" y="623708"/>
                        <a:pt x="557784" y="640080"/>
                      </a:cubicBezTo>
                      <a:cubicBezTo>
                        <a:pt x="555818" y="667611"/>
                        <a:pt x="562390" y="695151"/>
                        <a:pt x="566928" y="722376"/>
                      </a:cubicBezTo>
                      <a:cubicBezTo>
                        <a:pt x="573914" y="764290"/>
                        <a:pt x="615870" y="810547"/>
                        <a:pt x="658368" y="813816"/>
                      </a:cubicBezTo>
                      <a:lnTo>
                        <a:pt x="777240" y="822960"/>
                      </a:lnTo>
                      <a:cubicBezTo>
                        <a:pt x="801624" y="829056"/>
                        <a:pt x="830123" y="826384"/>
                        <a:pt x="850392" y="841248"/>
                      </a:cubicBezTo>
                      <a:cubicBezTo>
                        <a:pt x="878417" y="861799"/>
                        <a:pt x="914400" y="923544"/>
                        <a:pt x="914400" y="923544"/>
                      </a:cubicBezTo>
                      <a:cubicBezTo>
                        <a:pt x="913103" y="946899"/>
                        <a:pt x="916629" y="1070000"/>
                        <a:pt x="896112" y="1124712"/>
                      </a:cubicBezTo>
                      <a:cubicBezTo>
                        <a:pt x="891326" y="1137475"/>
                        <a:pt x="883920" y="1149096"/>
                        <a:pt x="877824" y="1161288"/>
                      </a:cubicBezTo>
                      <a:cubicBezTo>
                        <a:pt x="874776" y="1176528"/>
                        <a:pt x="865632" y="1191768"/>
                        <a:pt x="868680" y="1207008"/>
                      </a:cubicBezTo>
                      <a:cubicBezTo>
                        <a:pt x="872166" y="1224436"/>
                        <a:pt x="886692" y="1237657"/>
                        <a:pt x="896112" y="1252728"/>
                      </a:cubicBezTo>
                      <a:cubicBezTo>
                        <a:pt x="901937" y="1262047"/>
                        <a:pt x="904858" y="1274708"/>
                        <a:pt x="914400" y="1280160"/>
                      </a:cubicBezTo>
                      <a:cubicBezTo>
                        <a:pt x="927894" y="1287871"/>
                        <a:pt x="944948" y="1285933"/>
                        <a:pt x="960120" y="1289304"/>
                      </a:cubicBezTo>
                      <a:cubicBezTo>
                        <a:pt x="1037725" y="1306550"/>
                        <a:pt x="949750" y="1291741"/>
                        <a:pt x="1060704" y="1307592"/>
                      </a:cubicBezTo>
                      <a:cubicBezTo>
                        <a:pt x="1072896" y="1319784"/>
                        <a:pt x="1095141" y="1327059"/>
                        <a:pt x="1097280" y="1344168"/>
                      </a:cubicBezTo>
                      <a:cubicBezTo>
                        <a:pt x="1099170" y="1359290"/>
                        <a:pt x="1080624" y="1369968"/>
                        <a:pt x="1069848" y="1380744"/>
                      </a:cubicBezTo>
                      <a:cubicBezTo>
                        <a:pt x="1052122" y="1398470"/>
                        <a:pt x="1037295" y="1400739"/>
                        <a:pt x="1014984" y="1408176"/>
                      </a:cubicBezTo>
                      <a:cubicBezTo>
                        <a:pt x="1008888" y="1417320"/>
                        <a:pt x="1003443" y="1426933"/>
                        <a:pt x="996696" y="1435608"/>
                      </a:cubicBezTo>
                      <a:cubicBezTo>
                        <a:pt x="982081" y="1454399"/>
                        <a:pt x="956140" y="1467233"/>
                        <a:pt x="950976" y="1490472"/>
                      </a:cubicBezTo>
                      <a:cubicBezTo>
                        <a:pt x="939911" y="1540266"/>
                        <a:pt x="947015" y="1602030"/>
                        <a:pt x="987552" y="1636776"/>
                      </a:cubicBezTo>
                      <a:cubicBezTo>
                        <a:pt x="997901" y="1645647"/>
                        <a:pt x="1012293" y="1648301"/>
                        <a:pt x="1024128" y="1655064"/>
                      </a:cubicBezTo>
                      <a:cubicBezTo>
                        <a:pt x="1033670" y="1660516"/>
                        <a:pt x="1040637" y="1672138"/>
                        <a:pt x="1051560" y="1673352"/>
                      </a:cubicBezTo>
                      <a:cubicBezTo>
                        <a:pt x="1097000" y="1678401"/>
                        <a:pt x="1143000" y="1673352"/>
                        <a:pt x="1188720" y="1673352"/>
                      </a:cubicBezTo>
                    </a:path>
                  </a:pathLst>
                </a:custGeom>
                <a:noFill/>
                <a:ln>
                  <a:solidFill>
                    <a:schemeClr val="bg1"/>
                  </a:solidFill>
                  <a:prstDash val="sysDash"/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cxnSp>
              <p:nvCxnSpPr>
                <p:cNvPr id="10" name="Straight Arrow Connector 9">
                  <a:extLst>
                    <a:ext uri="{FF2B5EF4-FFF2-40B4-BE49-F238E27FC236}">
                      <a16:creationId xmlns:a16="http://schemas.microsoft.com/office/drawing/2014/main" id="{D305FAAE-405D-8A99-6995-D3815D664C98}"/>
                    </a:ext>
                  </a:extLst>
                </p:cNvPr>
                <p:cNvCxnSpPr/>
                <p:nvPr/>
              </p:nvCxnSpPr>
              <p:spPr>
                <a:xfrm flipV="1">
                  <a:off x="5093208" y="3026664"/>
                  <a:ext cx="64008" cy="164592"/>
                </a:xfrm>
                <a:prstGeom prst="straightConnector1">
                  <a:avLst/>
                </a:prstGeom>
                <a:ln>
                  <a:solidFill>
                    <a:srgbClr val="FFC000"/>
                  </a:solidFill>
                  <a:tailEnd type="triangle"/>
                </a:ln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1" name="Straight Arrow Connector 10">
                  <a:extLst>
                    <a:ext uri="{FF2B5EF4-FFF2-40B4-BE49-F238E27FC236}">
                      <a16:creationId xmlns:a16="http://schemas.microsoft.com/office/drawing/2014/main" id="{79537813-E1D0-C80C-AFE7-84B7C73F9509}"/>
                    </a:ext>
                  </a:extLst>
                </p:cNvPr>
                <p:cNvCxnSpPr/>
                <p:nvPr/>
              </p:nvCxnSpPr>
              <p:spPr>
                <a:xfrm flipV="1">
                  <a:off x="5821680" y="2182368"/>
                  <a:ext cx="64008" cy="164592"/>
                </a:xfrm>
                <a:prstGeom prst="straightConnector1">
                  <a:avLst/>
                </a:prstGeom>
                <a:ln>
                  <a:solidFill>
                    <a:srgbClr val="FF0000"/>
                  </a:solidFill>
                  <a:tailEnd type="triangle"/>
                </a:ln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2" name="Straight Arrow Connector 11">
                  <a:extLst>
                    <a:ext uri="{FF2B5EF4-FFF2-40B4-BE49-F238E27FC236}">
                      <a16:creationId xmlns:a16="http://schemas.microsoft.com/office/drawing/2014/main" id="{4880544E-6043-2188-1FDB-607DA5336E46}"/>
                    </a:ext>
                  </a:extLst>
                </p:cNvPr>
                <p:cNvCxnSpPr/>
                <p:nvPr/>
              </p:nvCxnSpPr>
              <p:spPr>
                <a:xfrm flipV="1">
                  <a:off x="4843272" y="2566416"/>
                  <a:ext cx="64008" cy="164592"/>
                </a:xfrm>
                <a:prstGeom prst="straightConnector1">
                  <a:avLst/>
                </a:prstGeom>
                <a:ln>
                  <a:solidFill>
                    <a:srgbClr val="FFC000"/>
                  </a:solidFill>
                  <a:tailEnd type="triangle"/>
                </a:ln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3" name="Straight Arrow Connector 12">
                  <a:extLst>
                    <a:ext uri="{FF2B5EF4-FFF2-40B4-BE49-F238E27FC236}">
                      <a16:creationId xmlns:a16="http://schemas.microsoft.com/office/drawing/2014/main" id="{D49D10E4-2F18-CB72-9552-292C7CC9D4C2}"/>
                    </a:ext>
                  </a:extLst>
                </p:cNvPr>
                <p:cNvCxnSpPr/>
                <p:nvPr/>
              </p:nvCxnSpPr>
              <p:spPr>
                <a:xfrm flipV="1">
                  <a:off x="6367272" y="2883408"/>
                  <a:ext cx="64008" cy="164592"/>
                </a:xfrm>
                <a:prstGeom prst="straightConnector1">
                  <a:avLst/>
                </a:prstGeom>
                <a:ln>
                  <a:solidFill>
                    <a:srgbClr val="FF0000"/>
                  </a:solidFill>
                  <a:tailEnd type="triangle"/>
                </a:ln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4" name="TextBox 3">
                <a:extLst>
                  <a:ext uri="{FF2B5EF4-FFF2-40B4-BE49-F238E27FC236}">
                    <a16:creationId xmlns:a16="http://schemas.microsoft.com/office/drawing/2014/main" id="{845A4029-8ABB-588C-A88E-990E547253DC}"/>
                  </a:ext>
                </a:extLst>
              </p:cNvPr>
              <p:cNvSpPr txBox="1"/>
              <p:nvPr/>
            </p:nvSpPr>
            <p:spPr>
              <a:xfrm>
                <a:off x="1743733" y="1839437"/>
                <a:ext cx="3406702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>
                    <a:solidFill>
                      <a:schemeClr val="bg1"/>
                    </a:solidFill>
                    <a:latin typeface="Calibri" panose="020F0502020204030204" pitchFamily="34" charset="0"/>
                    <a:ea typeface="Calibri" panose="020F0502020204030204" pitchFamily="34" charset="0"/>
                    <a:cs typeface="Calibri" panose="020F0502020204030204" pitchFamily="34" charset="0"/>
                  </a:rPr>
                  <a:t>HC                                                  </a:t>
                </a:r>
                <a:r>
                  <a:rPr lang="en-US" err="1">
                    <a:solidFill>
                      <a:schemeClr val="bg1"/>
                    </a:solidFill>
                    <a:latin typeface="Calibri" panose="020F0502020204030204" pitchFamily="34" charset="0"/>
                    <a:ea typeface="Calibri" panose="020F0502020204030204" pitchFamily="34" charset="0"/>
                    <a:cs typeface="Calibri" panose="020F0502020204030204" pitchFamily="34" charset="0"/>
                  </a:rPr>
                  <a:t>SSc</a:t>
                </a:r>
                <a:endParaRPr lang="en-US">
                  <a:solidFill>
                    <a:schemeClr val="bg1"/>
                  </a:solidFill>
                  <a:latin typeface="Calibri" panose="020F0502020204030204" pitchFamily="34" charset="0"/>
                  <a:ea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  <p:sp>
            <p:nvSpPr>
              <p:cNvPr id="5" name="TextBox 4">
                <a:extLst>
                  <a:ext uri="{FF2B5EF4-FFF2-40B4-BE49-F238E27FC236}">
                    <a16:creationId xmlns:a16="http://schemas.microsoft.com/office/drawing/2014/main" id="{D3B6168B-AC76-924F-0183-E38BA977AF2B}"/>
                  </a:ext>
                </a:extLst>
              </p:cNvPr>
              <p:cNvSpPr txBox="1"/>
              <p:nvPr/>
            </p:nvSpPr>
            <p:spPr>
              <a:xfrm rot="16200000">
                <a:off x="907508" y="2956859"/>
                <a:ext cx="1572290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400">
                    <a:solidFill>
                      <a:schemeClr val="accent6">
                        <a:lumMod val="60000"/>
                        <a:lumOff val="40000"/>
                      </a:schemeClr>
                    </a:solidFill>
                    <a:latin typeface="Calibri" panose="020F0502020204030204" pitchFamily="34" charset="0"/>
                    <a:ea typeface="Calibri" panose="020F0502020204030204" pitchFamily="34" charset="0"/>
                    <a:cs typeface="Calibri" panose="020F0502020204030204" pitchFamily="34" charset="0"/>
                  </a:rPr>
                  <a:t>IL-23</a:t>
                </a:r>
                <a:r>
                  <a:rPr lang="en-US" sz="1400">
                    <a:latin typeface="Calibri" panose="020F0502020204030204" pitchFamily="34" charset="0"/>
                    <a:ea typeface="Calibri" panose="020F0502020204030204" pitchFamily="34" charset="0"/>
                    <a:cs typeface="Calibri" panose="020F0502020204030204" pitchFamily="34" charset="0"/>
                  </a:rPr>
                  <a:t>/</a:t>
                </a:r>
                <a:r>
                  <a:rPr lang="en-US" sz="1400">
                    <a:solidFill>
                      <a:srgbClr val="F84EFC"/>
                    </a:solidFill>
                    <a:latin typeface="Calibri" panose="020F0502020204030204" pitchFamily="34" charset="0"/>
                    <a:ea typeface="Calibri" panose="020F0502020204030204" pitchFamily="34" charset="0"/>
                    <a:cs typeface="Calibri" panose="020F0502020204030204" pitchFamily="34" charset="0"/>
                  </a:rPr>
                  <a:t>Procol I</a:t>
                </a:r>
                <a:r>
                  <a:rPr lang="en-US" sz="1400">
                    <a:latin typeface="Calibri" panose="020F0502020204030204" pitchFamily="34" charset="0"/>
                    <a:ea typeface="Calibri" panose="020F0502020204030204" pitchFamily="34" charset="0"/>
                    <a:cs typeface="Calibri" panose="020F0502020204030204" pitchFamily="34" charset="0"/>
                  </a:rPr>
                  <a:t>/</a:t>
                </a:r>
                <a:r>
                  <a:rPr lang="en-US" sz="1400">
                    <a:solidFill>
                      <a:srgbClr val="0070C0"/>
                    </a:solidFill>
                    <a:latin typeface="Calibri" panose="020F0502020204030204" pitchFamily="34" charset="0"/>
                    <a:ea typeface="Calibri" panose="020F0502020204030204" pitchFamily="34" charset="0"/>
                    <a:cs typeface="Calibri" panose="020F0502020204030204" pitchFamily="34" charset="0"/>
                  </a:rPr>
                  <a:t>DAPI</a:t>
                </a:r>
              </a:p>
            </p:txBody>
          </p:sp>
        </p:grpSp>
        <p:cxnSp>
          <p:nvCxnSpPr>
            <p:cNvPr id="14" name="Straight Arrow Connector 13">
              <a:extLst>
                <a:ext uri="{FF2B5EF4-FFF2-40B4-BE49-F238E27FC236}">
                  <a16:creationId xmlns:a16="http://schemas.microsoft.com/office/drawing/2014/main" id="{B6074F42-4E91-33AF-21C9-FA93EC7C23C6}"/>
                </a:ext>
              </a:extLst>
            </p:cNvPr>
            <p:cNvCxnSpPr/>
            <p:nvPr/>
          </p:nvCxnSpPr>
          <p:spPr>
            <a:xfrm flipV="1">
              <a:off x="2336597" y="2599542"/>
              <a:ext cx="64008" cy="164592"/>
            </a:xfrm>
            <a:prstGeom prst="straightConnector1">
              <a:avLst/>
            </a:prstGeom>
            <a:ln>
              <a:solidFill>
                <a:srgbClr val="FF0000"/>
              </a:solidFill>
              <a:tailEnd type="triangle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5" name="TextBox 14">
            <a:extLst>
              <a:ext uri="{FF2B5EF4-FFF2-40B4-BE49-F238E27FC236}">
                <a16:creationId xmlns:a16="http://schemas.microsoft.com/office/drawing/2014/main" id="{22C79BFC-AAEA-8FD2-10DF-E1163FEBCFBA}"/>
              </a:ext>
            </a:extLst>
          </p:cNvPr>
          <p:cNvSpPr txBox="1"/>
          <p:nvPr/>
        </p:nvSpPr>
        <p:spPr>
          <a:xfrm>
            <a:off x="120073" y="287680"/>
            <a:ext cx="3817584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800"/>
              <a:t>Supplementary Figure S1</a:t>
            </a:r>
          </a:p>
        </p:txBody>
      </p:sp>
      <p:sp>
        <p:nvSpPr>
          <p:cNvPr id="16" name="Rectangle 15">
            <a:extLst>
              <a:ext uri="{FF2B5EF4-FFF2-40B4-BE49-F238E27FC236}">
                <a16:creationId xmlns:a16="http://schemas.microsoft.com/office/drawing/2014/main" id="{065B8A1C-EC18-F99D-4D8A-046029242486}"/>
              </a:ext>
            </a:extLst>
          </p:cNvPr>
          <p:cNvSpPr/>
          <p:nvPr/>
        </p:nvSpPr>
        <p:spPr>
          <a:xfrm>
            <a:off x="2461846" y="4334608"/>
            <a:ext cx="5767754" cy="45720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8" name="Rectangle 17">
            <a:extLst>
              <a:ext uri="{FF2B5EF4-FFF2-40B4-BE49-F238E27FC236}">
                <a16:creationId xmlns:a16="http://schemas.microsoft.com/office/drawing/2014/main" id="{8E99BB7D-E117-05B5-3D62-977C72871C97}"/>
              </a:ext>
            </a:extLst>
          </p:cNvPr>
          <p:cNvSpPr/>
          <p:nvPr/>
        </p:nvSpPr>
        <p:spPr>
          <a:xfrm>
            <a:off x="2461846" y="1732348"/>
            <a:ext cx="5767754" cy="45720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7170521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C3FC2949-8BC3-A387-982B-D050AB7D5536}"/>
              </a:ext>
            </a:extLst>
          </p:cNvPr>
          <p:cNvSpPr txBox="1"/>
          <p:nvPr/>
        </p:nvSpPr>
        <p:spPr>
          <a:xfrm>
            <a:off x="-30202" y="18473"/>
            <a:ext cx="3817584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800"/>
              <a:t>Supplementary Figure S2</a:t>
            </a:r>
          </a:p>
        </p:txBody>
      </p:sp>
      <p:grpSp>
        <p:nvGrpSpPr>
          <p:cNvPr id="25" name="Group 24">
            <a:extLst>
              <a:ext uri="{FF2B5EF4-FFF2-40B4-BE49-F238E27FC236}">
                <a16:creationId xmlns:a16="http://schemas.microsoft.com/office/drawing/2014/main" id="{37FA8FDF-0FE2-0BC5-DE76-72B8BCD3F097}"/>
              </a:ext>
            </a:extLst>
          </p:cNvPr>
          <p:cNvGrpSpPr/>
          <p:nvPr/>
        </p:nvGrpSpPr>
        <p:grpSpPr>
          <a:xfrm>
            <a:off x="2723233" y="685884"/>
            <a:ext cx="5975968" cy="2183525"/>
            <a:chOff x="-30202" y="1547987"/>
            <a:chExt cx="5975968" cy="2183525"/>
          </a:xfrm>
        </p:grpSpPr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D41C3C97-B55C-F8F8-332E-996827856E9B}"/>
                </a:ext>
              </a:extLst>
            </p:cNvPr>
            <p:cNvSpPr txBox="1"/>
            <p:nvPr/>
          </p:nvSpPr>
          <p:spPr>
            <a:xfrm rot="16200000">
              <a:off x="-409693" y="2662090"/>
              <a:ext cx="130424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>
                  <a:solidFill>
                    <a:srgbClr val="00B050"/>
                  </a:solidFill>
                  <a:latin typeface="Aptos" panose="020B0004020202020204" pitchFamily="34" charset="0"/>
                </a:rPr>
                <a:t>pSTAT3</a:t>
              </a:r>
              <a:r>
                <a:rPr lang="en-US" sz="1200">
                  <a:latin typeface="Aptos" panose="020B0004020202020204" pitchFamily="34" charset="0"/>
                </a:rPr>
                <a:t>/</a:t>
              </a:r>
              <a:r>
                <a:rPr lang="en-US" sz="1200">
                  <a:solidFill>
                    <a:srgbClr val="0070C0"/>
                  </a:solidFill>
                  <a:latin typeface="Aptos" panose="020B0004020202020204" pitchFamily="34" charset="0"/>
                </a:rPr>
                <a:t>DAPI</a:t>
              </a:r>
            </a:p>
          </p:txBody>
        </p:sp>
        <p:pic>
          <p:nvPicPr>
            <p:cNvPr id="7" name="Picture 6" descr="A close-up of a microscope&#10;&#10;Description automatically generated">
              <a:extLst>
                <a:ext uri="{FF2B5EF4-FFF2-40B4-BE49-F238E27FC236}">
                  <a16:creationId xmlns:a16="http://schemas.microsoft.com/office/drawing/2014/main" id="{9D61A2F2-A2D4-527A-6B57-0216F911452C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extLst>
                <a:ext uri="{BEBA8EAE-BF5A-486C-A8C5-ECC9F3942E4B}">
                  <a14:imgProps xmlns:a14="http://schemas.microsoft.com/office/drawing/2010/main">
                    <a14:imgLayer r:embed="rId3">
                      <a14:imgEffect>
                        <a14:brightnessContrast bright="20000"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 flipV="1">
              <a:off x="4048847" y="1900377"/>
              <a:ext cx="1828800" cy="1828800"/>
            </a:xfrm>
            <a:prstGeom prst="rect">
              <a:avLst/>
            </a:prstGeom>
          </p:spPr>
        </p:pic>
        <p:pic>
          <p:nvPicPr>
            <p:cNvPr id="9" name="Picture 8" descr="A close-up of a blue and green light&#10;&#10;Description automatically generated">
              <a:extLst>
                <a:ext uri="{FF2B5EF4-FFF2-40B4-BE49-F238E27FC236}">
                  <a16:creationId xmlns:a16="http://schemas.microsoft.com/office/drawing/2014/main" id="{7B1DD1E0-8828-B337-BE5D-940FC067FD56}"/>
                </a:ext>
              </a:extLst>
            </p:cNvPr>
            <p:cNvPicPr>
              <a:picLocks noChangeAspect="1"/>
            </p:cNvPicPr>
            <p:nvPr/>
          </p:nvPicPr>
          <p:blipFill>
            <a:blip r:embed="rId4">
              <a:extLst>
                <a:ext uri="{BEBA8EAE-BF5A-486C-A8C5-ECC9F3942E4B}">
                  <a14:imgProps xmlns:a14="http://schemas.microsoft.com/office/drawing/2010/main">
                    <a14:imgLayer r:embed="rId5">
                      <a14:imgEffect>
                        <a14:brightnessContrast bright="20000"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 rot="16200000">
              <a:off x="337384" y="1902712"/>
              <a:ext cx="1828800" cy="1828800"/>
            </a:xfrm>
            <a:prstGeom prst="rect">
              <a:avLst/>
            </a:prstGeom>
          </p:spPr>
        </p:pic>
        <p:pic>
          <p:nvPicPr>
            <p:cNvPr id="17" name="Picture 16" descr="A close-up of a microscope&#10;&#10;Description automatically generated">
              <a:extLst>
                <a:ext uri="{FF2B5EF4-FFF2-40B4-BE49-F238E27FC236}">
                  <a16:creationId xmlns:a16="http://schemas.microsoft.com/office/drawing/2014/main" id="{138ABE08-B9F8-C00C-6FFF-633DFFDD8ED4}"/>
                </a:ext>
              </a:extLst>
            </p:cNvPr>
            <p:cNvPicPr>
              <a:picLocks noChangeAspect="1"/>
            </p:cNvPicPr>
            <p:nvPr/>
          </p:nvPicPr>
          <p:blipFill>
            <a:blip r:embed="rId6">
              <a:extLst>
                <a:ext uri="{BEBA8EAE-BF5A-486C-A8C5-ECC9F3942E4B}">
                  <a14:imgProps xmlns:a14="http://schemas.microsoft.com/office/drawing/2010/main">
                    <a14:imgLayer r:embed="rId7">
                      <a14:imgEffect>
                        <a14:brightnessContrast bright="20000"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 rot="10800000">
              <a:off x="2193257" y="1902712"/>
              <a:ext cx="1828800" cy="1828800"/>
            </a:xfrm>
            <a:prstGeom prst="rect">
              <a:avLst/>
            </a:prstGeom>
          </p:spPr>
        </p:pic>
        <p:sp>
          <p:nvSpPr>
            <p:cNvPr id="18" name="TextBox 17">
              <a:extLst>
                <a:ext uri="{FF2B5EF4-FFF2-40B4-BE49-F238E27FC236}">
                  <a16:creationId xmlns:a16="http://schemas.microsoft.com/office/drawing/2014/main" id="{FE8CF7CB-5C96-4D49-64DE-247BE2271A80}"/>
                </a:ext>
              </a:extLst>
            </p:cNvPr>
            <p:cNvSpPr txBox="1"/>
            <p:nvPr/>
          </p:nvSpPr>
          <p:spPr>
            <a:xfrm>
              <a:off x="1644610" y="1867066"/>
              <a:ext cx="498855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>
                  <a:solidFill>
                    <a:schemeClr val="bg1"/>
                  </a:solidFill>
                  <a:latin typeface="Aptos" panose="020B0004020202020204" pitchFamily="34" charset="0"/>
                </a:rPr>
                <a:t>PBS</a:t>
              </a:r>
            </a:p>
          </p:txBody>
        </p:sp>
        <p:sp>
          <p:nvSpPr>
            <p:cNvPr id="19" name="TextBox 18">
              <a:extLst>
                <a:ext uri="{FF2B5EF4-FFF2-40B4-BE49-F238E27FC236}">
                  <a16:creationId xmlns:a16="http://schemas.microsoft.com/office/drawing/2014/main" id="{CBA9CB8F-AFD1-73ED-A10D-1387BC5A708F}"/>
                </a:ext>
              </a:extLst>
            </p:cNvPr>
            <p:cNvSpPr txBox="1"/>
            <p:nvPr/>
          </p:nvSpPr>
          <p:spPr>
            <a:xfrm>
              <a:off x="3524395" y="1851135"/>
              <a:ext cx="524503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>
                  <a:solidFill>
                    <a:schemeClr val="bg1"/>
                  </a:solidFill>
                  <a:latin typeface="Aptos" panose="020B0004020202020204" pitchFamily="34" charset="0"/>
                </a:rPr>
                <a:t>BLM</a:t>
              </a:r>
            </a:p>
          </p:txBody>
        </p:sp>
        <p:sp>
          <p:nvSpPr>
            <p:cNvPr id="20" name="TextBox 19">
              <a:extLst>
                <a:ext uri="{FF2B5EF4-FFF2-40B4-BE49-F238E27FC236}">
                  <a16:creationId xmlns:a16="http://schemas.microsoft.com/office/drawing/2014/main" id="{E35E3D8F-90B8-61CD-6801-01F10D178722}"/>
                </a:ext>
              </a:extLst>
            </p:cNvPr>
            <p:cNvSpPr txBox="1"/>
            <p:nvPr/>
          </p:nvSpPr>
          <p:spPr>
            <a:xfrm>
              <a:off x="4704721" y="1875851"/>
              <a:ext cx="1241045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>
                  <a:solidFill>
                    <a:schemeClr val="bg1"/>
                  </a:solidFill>
                  <a:latin typeface="Aptos" panose="020B0004020202020204" pitchFamily="34" charset="0"/>
                </a:rPr>
                <a:t>BLM+IL23ab</a:t>
              </a:r>
              <a:r>
                <a:rPr lang="en-US" sz="1400" baseline="30000">
                  <a:solidFill>
                    <a:schemeClr val="bg1"/>
                  </a:solidFill>
                  <a:latin typeface="Aptos" panose="020B0004020202020204" pitchFamily="34" charset="0"/>
                </a:rPr>
                <a:t>hi</a:t>
              </a:r>
            </a:p>
          </p:txBody>
        </p:sp>
        <p:sp>
          <p:nvSpPr>
            <p:cNvPr id="21" name="TextBox 20">
              <a:extLst>
                <a:ext uri="{FF2B5EF4-FFF2-40B4-BE49-F238E27FC236}">
                  <a16:creationId xmlns:a16="http://schemas.microsoft.com/office/drawing/2014/main" id="{37A30F81-D874-CE82-4CA2-1F504B12C48C}"/>
                </a:ext>
              </a:extLst>
            </p:cNvPr>
            <p:cNvSpPr txBox="1"/>
            <p:nvPr/>
          </p:nvSpPr>
          <p:spPr>
            <a:xfrm>
              <a:off x="-30202" y="1547987"/>
              <a:ext cx="393056" cy="5232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2800"/>
                <a:t>A</a:t>
              </a:r>
            </a:p>
          </p:txBody>
        </p:sp>
      </p:grpSp>
      <p:grpSp>
        <p:nvGrpSpPr>
          <p:cNvPr id="26" name="Group 25">
            <a:extLst>
              <a:ext uri="{FF2B5EF4-FFF2-40B4-BE49-F238E27FC236}">
                <a16:creationId xmlns:a16="http://schemas.microsoft.com/office/drawing/2014/main" id="{390BB2BE-D08F-FD9D-7E16-8F64DF86281B}"/>
              </a:ext>
            </a:extLst>
          </p:cNvPr>
          <p:cNvGrpSpPr/>
          <p:nvPr/>
        </p:nvGrpSpPr>
        <p:grpSpPr>
          <a:xfrm>
            <a:off x="2799670" y="2997908"/>
            <a:ext cx="5889577" cy="2115285"/>
            <a:chOff x="6207889" y="1662722"/>
            <a:chExt cx="5889577" cy="2115285"/>
          </a:xfrm>
        </p:grpSpPr>
        <p:grpSp>
          <p:nvGrpSpPr>
            <p:cNvPr id="3" name="Group 2">
              <a:extLst>
                <a:ext uri="{FF2B5EF4-FFF2-40B4-BE49-F238E27FC236}">
                  <a16:creationId xmlns:a16="http://schemas.microsoft.com/office/drawing/2014/main" id="{63E0ED8D-F24E-CB70-982B-57FDD06E76FC}"/>
                </a:ext>
              </a:extLst>
            </p:cNvPr>
            <p:cNvGrpSpPr/>
            <p:nvPr/>
          </p:nvGrpSpPr>
          <p:grpSpPr>
            <a:xfrm>
              <a:off x="6251968" y="1947227"/>
              <a:ext cx="5791891" cy="1830780"/>
              <a:chOff x="6251968" y="1947227"/>
              <a:chExt cx="5791891" cy="1830780"/>
            </a:xfrm>
          </p:grpSpPr>
          <p:pic>
            <p:nvPicPr>
              <p:cNvPr id="33" name="Picture 32" descr="A microscope view of a cell&#10;&#10;Description automatically generated">
                <a:extLst>
                  <a:ext uri="{FF2B5EF4-FFF2-40B4-BE49-F238E27FC236}">
                    <a16:creationId xmlns:a16="http://schemas.microsoft.com/office/drawing/2014/main" id="{1FFCBA63-73BE-62D6-717A-C694F1502A15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8">
                <a:extLst>
                  <a:ext uri="{BEBA8EAE-BF5A-486C-A8C5-ECC9F3942E4B}">
                    <a14:imgProps xmlns:a14="http://schemas.microsoft.com/office/drawing/2010/main">
                      <a14:imgLayer r:embed="rId9">
                        <a14:imgEffect>
                          <a14:brightnessContrast bright="40000" contrast="4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8358072" y="1949207"/>
                <a:ext cx="1828800" cy="1828800"/>
              </a:xfrm>
              <a:prstGeom prst="rect">
                <a:avLst/>
              </a:prstGeom>
            </p:spPr>
          </p:pic>
          <p:pic>
            <p:nvPicPr>
              <p:cNvPr id="34" name="Picture 33" descr="A microscope view of cells&#10;&#10;Description automatically generated">
                <a:extLst>
                  <a:ext uri="{FF2B5EF4-FFF2-40B4-BE49-F238E27FC236}">
                    <a16:creationId xmlns:a16="http://schemas.microsoft.com/office/drawing/2014/main" id="{D6CBEBBE-F55E-6E2A-BCD0-E52CFFA42D1C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0">
                <a:extLst>
                  <a:ext uri="{BEBA8EAE-BF5A-486C-A8C5-ECC9F3942E4B}">
                    <a14:imgProps xmlns:a14="http://schemas.microsoft.com/office/drawing/2010/main">
                      <a14:imgLayer r:embed="rId11">
                        <a14:imgEffect>
                          <a14:brightnessContrast bright="40000" contrast="4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10215059" y="1947698"/>
                <a:ext cx="1828800" cy="1828800"/>
              </a:xfrm>
              <a:prstGeom prst="rect">
                <a:avLst/>
              </a:prstGeom>
            </p:spPr>
          </p:pic>
          <p:pic>
            <p:nvPicPr>
              <p:cNvPr id="35" name="Picture 34" descr="A blue and green cells&#10;&#10;Description automatically generated">
                <a:extLst>
                  <a:ext uri="{FF2B5EF4-FFF2-40B4-BE49-F238E27FC236}">
                    <a16:creationId xmlns:a16="http://schemas.microsoft.com/office/drawing/2014/main" id="{FE8C3587-98F6-7385-E3B6-2D8E483C50F2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2">
                <a:extLst>
                  <a:ext uri="{BEBA8EAE-BF5A-486C-A8C5-ECC9F3942E4B}">
                    <a14:imgProps xmlns:a14="http://schemas.microsoft.com/office/drawing/2010/main">
                      <a14:imgLayer r:embed="rId13">
                        <a14:imgEffect>
                          <a14:brightnessContrast bright="40000" contrast="4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 flipV="1">
                <a:off x="6504386" y="1947227"/>
                <a:ext cx="1828800" cy="1828800"/>
              </a:xfrm>
              <a:prstGeom prst="rect">
                <a:avLst/>
              </a:prstGeom>
            </p:spPr>
          </p:pic>
          <p:sp>
            <p:nvSpPr>
              <p:cNvPr id="2" name="TextBox 1">
                <a:extLst>
                  <a:ext uri="{FF2B5EF4-FFF2-40B4-BE49-F238E27FC236}">
                    <a16:creationId xmlns:a16="http://schemas.microsoft.com/office/drawing/2014/main" id="{B4CAC212-C75C-008B-CB8C-08F5E6F26633}"/>
                  </a:ext>
                </a:extLst>
              </p:cNvPr>
              <p:cNvSpPr txBox="1"/>
              <p:nvPr/>
            </p:nvSpPr>
            <p:spPr>
              <a:xfrm rot="16200000">
                <a:off x="5738346" y="2643505"/>
                <a:ext cx="1304244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>
                    <a:solidFill>
                      <a:srgbClr val="00B050"/>
                    </a:solidFill>
                    <a:latin typeface="Aptos" panose="020B0004020202020204" pitchFamily="34" charset="0"/>
                  </a:rPr>
                  <a:t>pSTAT3</a:t>
                </a:r>
                <a:r>
                  <a:rPr lang="en-US" sz="1200">
                    <a:latin typeface="Aptos" panose="020B0004020202020204" pitchFamily="34" charset="0"/>
                  </a:rPr>
                  <a:t>/</a:t>
                </a:r>
                <a:r>
                  <a:rPr lang="en-US" sz="1200">
                    <a:solidFill>
                      <a:srgbClr val="0070C0"/>
                    </a:solidFill>
                    <a:latin typeface="Aptos" panose="020B0004020202020204" pitchFamily="34" charset="0"/>
                  </a:rPr>
                  <a:t>DAPI</a:t>
                </a:r>
              </a:p>
            </p:txBody>
          </p:sp>
        </p:grpSp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id="{49183B50-2C3E-A9AC-3E04-5E7752229091}"/>
                </a:ext>
              </a:extLst>
            </p:cNvPr>
            <p:cNvSpPr txBox="1"/>
            <p:nvPr/>
          </p:nvSpPr>
          <p:spPr>
            <a:xfrm>
              <a:off x="7849441" y="2228390"/>
              <a:ext cx="498855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>
                  <a:solidFill>
                    <a:schemeClr val="bg1"/>
                  </a:solidFill>
                  <a:latin typeface="Aptos" panose="020B0004020202020204" pitchFamily="34" charset="0"/>
                </a:rPr>
                <a:t>PBS</a:t>
              </a:r>
            </a:p>
          </p:txBody>
        </p:sp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200BBC18-A3C7-4617-B020-DA22BBE4272C}"/>
                </a:ext>
              </a:extLst>
            </p:cNvPr>
            <p:cNvSpPr txBox="1"/>
            <p:nvPr/>
          </p:nvSpPr>
          <p:spPr>
            <a:xfrm>
              <a:off x="9655302" y="2213067"/>
              <a:ext cx="524503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>
                  <a:solidFill>
                    <a:schemeClr val="bg1"/>
                  </a:solidFill>
                  <a:latin typeface="Aptos" panose="020B0004020202020204" pitchFamily="34" charset="0"/>
                </a:rPr>
                <a:t>BLM</a:t>
              </a:r>
            </a:p>
          </p:txBody>
        </p:sp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id="{71163E0E-1A29-D5A5-93D3-B450231BD468}"/>
                </a:ext>
              </a:extLst>
            </p:cNvPr>
            <p:cNvSpPr txBox="1"/>
            <p:nvPr/>
          </p:nvSpPr>
          <p:spPr>
            <a:xfrm>
              <a:off x="10856421" y="2236819"/>
              <a:ext cx="1241045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>
                  <a:solidFill>
                    <a:schemeClr val="bg1"/>
                  </a:solidFill>
                  <a:latin typeface="Aptos" panose="020B0004020202020204" pitchFamily="34" charset="0"/>
                </a:rPr>
                <a:t>BLM+IL23ab</a:t>
              </a:r>
              <a:r>
                <a:rPr lang="en-US" sz="1400" baseline="30000">
                  <a:solidFill>
                    <a:schemeClr val="bg1"/>
                  </a:solidFill>
                  <a:latin typeface="Aptos" panose="020B0004020202020204" pitchFamily="34" charset="0"/>
                </a:rPr>
                <a:t>hi</a:t>
              </a:r>
            </a:p>
          </p:txBody>
        </p:sp>
        <p:sp>
          <p:nvSpPr>
            <p:cNvPr id="22" name="TextBox 21">
              <a:extLst>
                <a:ext uri="{FF2B5EF4-FFF2-40B4-BE49-F238E27FC236}">
                  <a16:creationId xmlns:a16="http://schemas.microsoft.com/office/drawing/2014/main" id="{8C562B08-5346-C517-2543-6FC5D911BC11}"/>
                </a:ext>
              </a:extLst>
            </p:cNvPr>
            <p:cNvSpPr txBox="1"/>
            <p:nvPr/>
          </p:nvSpPr>
          <p:spPr>
            <a:xfrm>
              <a:off x="6207889" y="1662722"/>
              <a:ext cx="380232" cy="5232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2800"/>
                <a:t>B</a:t>
              </a:r>
            </a:p>
          </p:txBody>
        </p:sp>
      </p:grpSp>
      <p:graphicFrame>
        <p:nvGraphicFramePr>
          <p:cNvPr id="10" name="Object 9">
            <a:extLst>
              <a:ext uri="{FF2B5EF4-FFF2-40B4-BE49-F238E27FC236}">
                <a16:creationId xmlns:a16="http://schemas.microsoft.com/office/drawing/2014/main" id="{B009A03A-DA12-9A3C-7D91-97BB77ACFB01}"/>
              </a:ext>
            </a:extLst>
          </p:cNvPr>
          <p:cNvGraphicFramePr>
            <a:graphicFrameLocks noChangeAspect="1"/>
          </p:cNvGraphicFramePr>
          <p:nvPr/>
        </p:nvGraphicFramePr>
        <p:xfrm>
          <a:off x="8619271" y="248383"/>
          <a:ext cx="2252662" cy="274478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14" imgW="2251929" imgH="2744374" progId="Prism10.Document">
                  <p:embed/>
                </p:oleObj>
              </mc:Choice>
              <mc:Fallback>
                <p:oleObj name="Prism 10" r:id="rId14" imgW="2251929" imgH="2744374" progId="Prism10.Document">
                  <p:embed/>
                  <p:pic>
                    <p:nvPicPr>
                      <p:cNvPr id="10" name="Object 9">
                        <a:extLst>
                          <a:ext uri="{FF2B5EF4-FFF2-40B4-BE49-F238E27FC236}">
                            <a16:creationId xmlns:a16="http://schemas.microsoft.com/office/drawing/2014/main" id="{B009A03A-DA12-9A3C-7D91-97BB77ACFB01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5"/>
                      <a:stretch>
                        <a:fillRect/>
                      </a:stretch>
                    </p:blipFill>
                    <p:spPr>
                      <a:xfrm>
                        <a:off x="8619271" y="248383"/>
                        <a:ext cx="2252662" cy="274478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6" name="TextBox 15">
            <a:extLst>
              <a:ext uri="{FF2B5EF4-FFF2-40B4-BE49-F238E27FC236}">
                <a16:creationId xmlns:a16="http://schemas.microsoft.com/office/drawing/2014/main" id="{754D8409-C51C-547A-5934-B4DB64BC36AA}"/>
              </a:ext>
            </a:extLst>
          </p:cNvPr>
          <p:cNvSpPr txBox="1"/>
          <p:nvPr/>
        </p:nvSpPr>
        <p:spPr>
          <a:xfrm>
            <a:off x="9267357" y="2684584"/>
            <a:ext cx="152317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/>
              <a:t>PBS     </a:t>
            </a:r>
            <a:r>
              <a:rPr lang="en-US" sz="1200" err="1"/>
              <a:t>Bleo</a:t>
            </a:r>
            <a:r>
              <a:rPr lang="en-US" sz="1200"/>
              <a:t>   </a:t>
            </a:r>
            <a:r>
              <a:rPr lang="en-US" sz="1200" err="1"/>
              <a:t>Bleo</a:t>
            </a:r>
            <a:endParaRPr lang="en-US" sz="1200"/>
          </a:p>
          <a:p>
            <a:r>
              <a:rPr lang="en-US" sz="1200"/>
              <a:t>                       IL23ab</a:t>
            </a:r>
            <a:r>
              <a:rPr lang="en-US" sz="1200" baseline="30000"/>
              <a:t>hi</a:t>
            </a:r>
            <a:r>
              <a:rPr lang="en-US" sz="1200"/>
              <a:t> </a:t>
            </a:r>
          </a:p>
        </p:txBody>
      </p:sp>
      <p:graphicFrame>
        <p:nvGraphicFramePr>
          <p:cNvPr id="23" name="Object 22">
            <a:extLst>
              <a:ext uri="{FF2B5EF4-FFF2-40B4-BE49-F238E27FC236}">
                <a16:creationId xmlns:a16="http://schemas.microsoft.com/office/drawing/2014/main" id="{DC40232E-F7AC-01CE-1C38-562029DE13A6}"/>
              </a:ext>
            </a:extLst>
          </p:cNvPr>
          <p:cNvGraphicFramePr>
            <a:graphicFrameLocks noChangeAspect="1"/>
          </p:cNvGraphicFramePr>
          <p:nvPr/>
        </p:nvGraphicFramePr>
        <p:xfrm>
          <a:off x="8689365" y="3072544"/>
          <a:ext cx="2259012" cy="30432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16" imgW="2259491" imgH="3043302" progId="Prism10.Document">
                  <p:embed/>
                </p:oleObj>
              </mc:Choice>
              <mc:Fallback>
                <p:oleObj name="Prism 10" r:id="rId16" imgW="2259491" imgH="3043302" progId="Prism10.Document">
                  <p:embed/>
                  <p:pic>
                    <p:nvPicPr>
                      <p:cNvPr id="23" name="Object 22">
                        <a:extLst>
                          <a:ext uri="{FF2B5EF4-FFF2-40B4-BE49-F238E27FC236}">
                            <a16:creationId xmlns:a16="http://schemas.microsoft.com/office/drawing/2014/main" id="{DC40232E-F7AC-01CE-1C38-562029DE13A6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7"/>
                      <a:stretch>
                        <a:fillRect/>
                      </a:stretch>
                    </p:blipFill>
                    <p:spPr>
                      <a:xfrm>
                        <a:off x="8689365" y="3072544"/>
                        <a:ext cx="2259012" cy="30432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24" name="TextBox 23">
            <a:extLst>
              <a:ext uri="{FF2B5EF4-FFF2-40B4-BE49-F238E27FC236}">
                <a16:creationId xmlns:a16="http://schemas.microsoft.com/office/drawing/2014/main" id="{1B965FC2-31CB-12F9-86E9-8DFAFCF27342}"/>
              </a:ext>
            </a:extLst>
          </p:cNvPr>
          <p:cNvSpPr txBox="1"/>
          <p:nvPr/>
        </p:nvSpPr>
        <p:spPr>
          <a:xfrm>
            <a:off x="9355103" y="5824200"/>
            <a:ext cx="152317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/>
              <a:t>PBS     </a:t>
            </a:r>
            <a:r>
              <a:rPr lang="en-US" sz="1200" err="1"/>
              <a:t>Bleo</a:t>
            </a:r>
            <a:r>
              <a:rPr lang="en-US" sz="1200"/>
              <a:t>   </a:t>
            </a:r>
            <a:r>
              <a:rPr lang="en-US" sz="1200" err="1"/>
              <a:t>Bleo</a:t>
            </a:r>
            <a:endParaRPr lang="en-US" sz="1200"/>
          </a:p>
          <a:p>
            <a:r>
              <a:rPr lang="en-US" sz="1200"/>
              <a:t>                       IL23ab</a:t>
            </a:r>
            <a:r>
              <a:rPr lang="en-US" sz="1200" baseline="30000"/>
              <a:t>hi</a:t>
            </a:r>
            <a:r>
              <a:rPr lang="en-US" sz="1200"/>
              <a:t> </a:t>
            </a:r>
          </a:p>
        </p:txBody>
      </p:sp>
      <p:sp>
        <p:nvSpPr>
          <p:cNvPr id="6" name="Rectangle 5">
            <a:extLst>
              <a:ext uri="{FF2B5EF4-FFF2-40B4-BE49-F238E27FC236}">
                <a16:creationId xmlns:a16="http://schemas.microsoft.com/office/drawing/2014/main" id="{C6925852-ED70-BEF5-38AC-9FA0B856D40B}"/>
              </a:ext>
            </a:extLst>
          </p:cNvPr>
          <p:cNvSpPr/>
          <p:nvPr/>
        </p:nvSpPr>
        <p:spPr>
          <a:xfrm>
            <a:off x="3093057" y="3064836"/>
            <a:ext cx="5602504" cy="504948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" name="Rectangle 4">
            <a:extLst>
              <a:ext uri="{FF2B5EF4-FFF2-40B4-BE49-F238E27FC236}">
                <a16:creationId xmlns:a16="http://schemas.microsoft.com/office/drawing/2014/main" id="{C535DC3F-CEDC-EDCB-1DAF-7A8AB57284C9}"/>
              </a:ext>
            </a:extLst>
          </p:cNvPr>
          <p:cNvSpPr/>
          <p:nvPr/>
        </p:nvSpPr>
        <p:spPr>
          <a:xfrm>
            <a:off x="2954215" y="2525576"/>
            <a:ext cx="5676867" cy="504948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0195536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6D62439A-0E0F-DDE1-6C56-90BD338F1727}"/>
              </a:ext>
            </a:extLst>
          </p:cNvPr>
          <p:cNvSpPr txBox="1"/>
          <p:nvPr/>
        </p:nvSpPr>
        <p:spPr>
          <a:xfrm>
            <a:off x="180216" y="209693"/>
            <a:ext cx="3817584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800"/>
              <a:t>Supplementary Figure S3</a:t>
            </a:r>
          </a:p>
        </p:txBody>
      </p:sp>
      <p:grpSp>
        <p:nvGrpSpPr>
          <p:cNvPr id="9" name="Group 8">
            <a:extLst>
              <a:ext uri="{FF2B5EF4-FFF2-40B4-BE49-F238E27FC236}">
                <a16:creationId xmlns:a16="http://schemas.microsoft.com/office/drawing/2014/main" id="{6128A3E2-5454-1D7F-EB3D-B49761DF2B2D}"/>
              </a:ext>
            </a:extLst>
          </p:cNvPr>
          <p:cNvGrpSpPr/>
          <p:nvPr/>
        </p:nvGrpSpPr>
        <p:grpSpPr>
          <a:xfrm>
            <a:off x="2368405" y="1267403"/>
            <a:ext cx="2282825" cy="2777941"/>
            <a:chOff x="2368405" y="1267403"/>
            <a:chExt cx="2282825" cy="2777941"/>
          </a:xfrm>
        </p:grpSpPr>
        <p:graphicFrame>
          <p:nvGraphicFramePr>
            <p:cNvPr id="3" name="Object 2">
              <a:extLst>
                <a:ext uri="{FF2B5EF4-FFF2-40B4-BE49-F238E27FC236}">
                  <a16:creationId xmlns:a16="http://schemas.microsoft.com/office/drawing/2014/main" id="{B75DAB70-29E0-4BE0-A93D-8715511E5306}"/>
                </a:ext>
              </a:extLst>
            </p:cNvPr>
            <p:cNvGraphicFramePr>
              <a:graphicFrameLocks noChangeAspect="1"/>
            </p:cNvGraphicFramePr>
            <p:nvPr/>
          </p:nvGraphicFramePr>
          <p:xfrm>
            <a:off x="2368405" y="1267403"/>
            <a:ext cx="2282825" cy="2659063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10" r:id="rId2" imgW="2282180" imgH="2659017" progId="Prism10.Document">
                    <p:embed/>
                  </p:oleObj>
                </mc:Choice>
                <mc:Fallback>
                  <p:oleObj name="Prism 10" r:id="rId2" imgW="2282180" imgH="2659017" progId="Prism10.Document">
                    <p:embed/>
                    <p:pic>
                      <p:nvPicPr>
                        <p:cNvPr id="3" name="Object 2">
                          <a:extLst>
                            <a:ext uri="{FF2B5EF4-FFF2-40B4-BE49-F238E27FC236}">
                              <a16:creationId xmlns:a16="http://schemas.microsoft.com/office/drawing/2014/main" id="{B75DAB70-29E0-4BE0-A93D-8715511E5306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3"/>
                        <a:stretch>
                          <a:fillRect/>
                        </a:stretch>
                      </p:blipFill>
                      <p:spPr>
                        <a:xfrm>
                          <a:off x="2368405" y="1267403"/>
                          <a:ext cx="2282825" cy="2659063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4" name="TextBox 3">
              <a:extLst>
                <a:ext uri="{FF2B5EF4-FFF2-40B4-BE49-F238E27FC236}">
                  <a16:creationId xmlns:a16="http://schemas.microsoft.com/office/drawing/2014/main" id="{A9983F60-EEF2-6B48-C048-BA8EC054E439}"/>
                </a:ext>
              </a:extLst>
            </p:cNvPr>
            <p:cNvSpPr txBox="1"/>
            <p:nvPr/>
          </p:nvSpPr>
          <p:spPr>
            <a:xfrm>
              <a:off x="3055025" y="3583679"/>
              <a:ext cx="1523174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/>
                <a:t>PBS     </a:t>
              </a:r>
              <a:r>
                <a:rPr lang="en-US" sz="1200" err="1"/>
                <a:t>Bleo</a:t>
              </a:r>
              <a:r>
                <a:rPr lang="en-US" sz="1200"/>
                <a:t>   </a:t>
              </a:r>
              <a:r>
                <a:rPr lang="en-US" sz="1200" err="1"/>
                <a:t>Bleo</a:t>
              </a:r>
              <a:endParaRPr lang="en-US" sz="1200"/>
            </a:p>
            <a:p>
              <a:r>
                <a:rPr lang="en-US" sz="1200"/>
                <a:t>                       IL23ab</a:t>
              </a:r>
              <a:r>
                <a:rPr lang="en-US" sz="1200" baseline="30000"/>
                <a:t>hi</a:t>
              </a:r>
              <a:r>
                <a:rPr lang="en-US" sz="1200"/>
                <a:t> </a:t>
              </a:r>
            </a:p>
          </p:txBody>
        </p:sp>
      </p:grpSp>
      <p:grpSp>
        <p:nvGrpSpPr>
          <p:cNvPr id="10" name="Group 9">
            <a:extLst>
              <a:ext uri="{FF2B5EF4-FFF2-40B4-BE49-F238E27FC236}">
                <a16:creationId xmlns:a16="http://schemas.microsoft.com/office/drawing/2014/main" id="{63128DD0-4508-2F60-495B-5176E9896655}"/>
              </a:ext>
            </a:extLst>
          </p:cNvPr>
          <p:cNvGrpSpPr/>
          <p:nvPr/>
        </p:nvGrpSpPr>
        <p:grpSpPr>
          <a:xfrm>
            <a:off x="4740997" y="1369148"/>
            <a:ext cx="2357437" cy="2671578"/>
            <a:chOff x="4740997" y="1332202"/>
            <a:chExt cx="2357437" cy="2671578"/>
          </a:xfrm>
        </p:grpSpPr>
        <p:graphicFrame>
          <p:nvGraphicFramePr>
            <p:cNvPr id="5" name="Object 4">
              <a:extLst>
                <a:ext uri="{FF2B5EF4-FFF2-40B4-BE49-F238E27FC236}">
                  <a16:creationId xmlns:a16="http://schemas.microsoft.com/office/drawing/2014/main" id="{5077CE38-806D-C393-CE75-1471ACD9524A}"/>
                </a:ext>
              </a:extLst>
            </p:cNvPr>
            <p:cNvGraphicFramePr>
              <a:graphicFrameLocks noChangeAspect="1"/>
            </p:cNvGraphicFramePr>
            <p:nvPr/>
          </p:nvGraphicFramePr>
          <p:xfrm>
            <a:off x="4740997" y="1332202"/>
            <a:ext cx="2357437" cy="254635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10" r:id="rId4" imgW="2357088" imgH="2546289" progId="Prism10.Document">
                    <p:embed/>
                  </p:oleObj>
                </mc:Choice>
                <mc:Fallback>
                  <p:oleObj name="Prism 10" r:id="rId4" imgW="2357088" imgH="2546289" progId="Prism10.Document">
                    <p:embed/>
                    <p:pic>
                      <p:nvPicPr>
                        <p:cNvPr id="5" name="Object 4">
                          <a:extLst>
                            <a:ext uri="{FF2B5EF4-FFF2-40B4-BE49-F238E27FC236}">
                              <a16:creationId xmlns:a16="http://schemas.microsoft.com/office/drawing/2014/main" id="{5077CE38-806D-C393-CE75-1471ACD9524A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5"/>
                        <a:stretch>
                          <a:fillRect/>
                        </a:stretch>
                      </p:blipFill>
                      <p:spPr>
                        <a:xfrm>
                          <a:off x="4740997" y="1332202"/>
                          <a:ext cx="2357437" cy="254635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AD15A76A-3B34-7660-8975-4B66F75D2613}"/>
                </a:ext>
              </a:extLst>
            </p:cNvPr>
            <p:cNvSpPr txBox="1"/>
            <p:nvPr/>
          </p:nvSpPr>
          <p:spPr>
            <a:xfrm>
              <a:off x="5479570" y="3542115"/>
              <a:ext cx="1523174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/>
                <a:t>PBS     </a:t>
              </a:r>
              <a:r>
                <a:rPr lang="en-US" sz="1200" err="1"/>
                <a:t>Bleo</a:t>
              </a:r>
              <a:r>
                <a:rPr lang="en-US" sz="1200"/>
                <a:t>   </a:t>
              </a:r>
              <a:r>
                <a:rPr lang="en-US" sz="1200" err="1"/>
                <a:t>Bleo</a:t>
              </a:r>
              <a:endParaRPr lang="en-US" sz="1200"/>
            </a:p>
            <a:p>
              <a:r>
                <a:rPr lang="en-US" sz="1200"/>
                <a:t>                       IL23ab</a:t>
              </a:r>
              <a:r>
                <a:rPr lang="en-US" sz="1200" baseline="30000"/>
                <a:t>hi</a:t>
              </a:r>
              <a:r>
                <a:rPr lang="en-US" sz="1200"/>
                <a:t> </a:t>
              </a:r>
            </a:p>
          </p:txBody>
        </p:sp>
      </p:grpSp>
      <p:grpSp>
        <p:nvGrpSpPr>
          <p:cNvPr id="11" name="Group 10">
            <a:extLst>
              <a:ext uri="{FF2B5EF4-FFF2-40B4-BE49-F238E27FC236}">
                <a16:creationId xmlns:a16="http://schemas.microsoft.com/office/drawing/2014/main" id="{6B3A0F3C-F3E4-B9BA-A516-B44EF9DC219A}"/>
              </a:ext>
            </a:extLst>
          </p:cNvPr>
          <p:cNvGrpSpPr/>
          <p:nvPr/>
        </p:nvGrpSpPr>
        <p:grpSpPr>
          <a:xfrm>
            <a:off x="7076498" y="1883497"/>
            <a:ext cx="2287588" cy="2161847"/>
            <a:chOff x="7058025" y="1855788"/>
            <a:chExt cx="2287588" cy="2161847"/>
          </a:xfrm>
        </p:grpSpPr>
        <p:graphicFrame>
          <p:nvGraphicFramePr>
            <p:cNvPr id="6" name="Object 5">
              <a:extLst>
                <a:ext uri="{FF2B5EF4-FFF2-40B4-BE49-F238E27FC236}">
                  <a16:creationId xmlns:a16="http://schemas.microsoft.com/office/drawing/2014/main" id="{1A04B807-82D8-A44C-8BE5-FA8F8EA15AC4}"/>
                </a:ext>
              </a:extLst>
            </p:cNvPr>
            <p:cNvGraphicFramePr>
              <a:graphicFrameLocks noChangeAspect="1"/>
            </p:cNvGraphicFramePr>
            <p:nvPr/>
          </p:nvGraphicFramePr>
          <p:xfrm>
            <a:off x="7058025" y="1855788"/>
            <a:ext cx="2287588" cy="2017712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10" r:id="rId6" imgW="2286862" imgH="2017223" progId="Prism10.Document">
                    <p:embed/>
                  </p:oleObj>
                </mc:Choice>
                <mc:Fallback>
                  <p:oleObj name="Prism 10" r:id="rId6" imgW="2286862" imgH="2017223" progId="Prism10.Document">
                    <p:embed/>
                    <p:pic>
                      <p:nvPicPr>
                        <p:cNvPr id="6" name="Object 5">
                          <a:extLst>
                            <a:ext uri="{FF2B5EF4-FFF2-40B4-BE49-F238E27FC236}">
                              <a16:creationId xmlns:a16="http://schemas.microsoft.com/office/drawing/2014/main" id="{1A04B807-82D8-A44C-8BE5-FA8F8EA15AC4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7"/>
                        <a:stretch>
                          <a:fillRect/>
                        </a:stretch>
                      </p:blipFill>
                      <p:spPr>
                        <a:xfrm>
                          <a:off x="7058025" y="1855788"/>
                          <a:ext cx="2287588" cy="2017712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99BAA419-1C9C-A6F5-7C04-8B1F11C2C0ED}"/>
                </a:ext>
              </a:extLst>
            </p:cNvPr>
            <p:cNvSpPr txBox="1"/>
            <p:nvPr/>
          </p:nvSpPr>
          <p:spPr>
            <a:xfrm>
              <a:off x="7756333" y="3555970"/>
              <a:ext cx="1523174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/>
                <a:t>PBS     </a:t>
              </a:r>
              <a:r>
                <a:rPr lang="en-US" sz="1200" err="1"/>
                <a:t>Bleo</a:t>
              </a:r>
              <a:r>
                <a:rPr lang="en-US" sz="1200"/>
                <a:t>   </a:t>
              </a:r>
              <a:r>
                <a:rPr lang="en-US" sz="1200" err="1"/>
                <a:t>Bleo</a:t>
              </a:r>
              <a:endParaRPr lang="en-US" sz="1200"/>
            </a:p>
            <a:p>
              <a:r>
                <a:rPr lang="en-US" sz="1200"/>
                <a:t>                       IL23ab</a:t>
              </a:r>
              <a:r>
                <a:rPr lang="en-US" sz="1200" baseline="30000"/>
                <a:t>hi</a:t>
              </a:r>
              <a:r>
                <a:rPr lang="en-US" sz="1200"/>
                <a:t> </a:t>
              </a:r>
            </a:p>
          </p:txBody>
        </p:sp>
      </p:grpSp>
      <p:sp>
        <p:nvSpPr>
          <p:cNvPr id="12" name="TextBox 11">
            <a:extLst>
              <a:ext uri="{FF2B5EF4-FFF2-40B4-BE49-F238E27FC236}">
                <a16:creationId xmlns:a16="http://schemas.microsoft.com/office/drawing/2014/main" id="{95617637-422E-2081-10CC-8B48D704AD55}"/>
              </a:ext>
            </a:extLst>
          </p:cNvPr>
          <p:cNvSpPr txBox="1"/>
          <p:nvPr/>
        </p:nvSpPr>
        <p:spPr>
          <a:xfrm>
            <a:off x="1559452" y="1045835"/>
            <a:ext cx="6093335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800"/>
              <a:t>  A                                  B                             C</a:t>
            </a:r>
          </a:p>
        </p:txBody>
      </p:sp>
    </p:spTree>
    <p:extLst>
      <p:ext uri="{BB962C8B-B14F-4D97-AF65-F5344CB8AC3E}">
        <p14:creationId xmlns:p14="http://schemas.microsoft.com/office/powerpoint/2010/main" val="4045285680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TextBox 7">
            <a:extLst>
              <a:ext uri="{FF2B5EF4-FFF2-40B4-BE49-F238E27FC236}">
                <a16:creationId xmlns:a16="http://schemas.microsoft.com/office/drawing/2014/main" id="{70B7F7DB-B57E-5939-4F02-D07281288F94}"/>
              </a:ext>
            </a:extLst>
          </p:cNvPr>
          <p:cNvSpPr txBox="1"/>
          <p:nvPr/>
        </p:nvSpPr>
        <p:spPr>
          <a:xfrm>
            <a:off x="259729" y="241498"/>
            <a:ext cx="3817584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800"/>
              <a:t>Supplementary Figure S4</a:t>
            </a:r>
          </a:p>
        </p:txBody>
      </p:sp>
      <p:grpSp>
        <p:nvGrpSpPr>
          <p:cNvPr id="3" name="Group 2">
            <a:extLst>
              <a:ext uri="{FF2B5EF4-FFF2-40B4-BE49-F238E27FC236}">
                <a16:creationId xmlns:a16="http://schemas.microsoft.com/office/drawing/2014/main" id="{C51745AC-FAAA-04A5-1873-2D1D293FCBA4}"/>
              </a:ext>
            </a:extLst>
          </p:cNvPr>
          <p:cNvGrpSpPr/>
          <p:nvPr/>
        </p:nvGrpSpPr>
        <p:grpSpPr>
          <a:xfrm>
            <a:off x="4031240" y="1598902"/>
            <a:ext cx="2268537" cy="2871314"/>
            <a:chOff x="2525713" y="1608138"/>
            <a:chExt cx="2268537" cy="2871314"/>
          </a:xfrm>
        </p:grpSpPr>
        <p:graphicFrame>
          <p:nvGraphicFramePr>
            <p:cNvPr id="2" name="Object 1">
              <a:extLst>
                <a:ext uri="{FF2B5EF4-FFF2-40B4-BE49-F238E27FC236}">
                  <a16:creationId xmlns:a16="http://schemas.microsoft.com/office/drawing/2014/main" id="{57AD35D3-A46E-B9F9-763E-257E88888F5F}"/>
                </a:ext>
              </a:extLst>
            </p:cNvPr>
            <p:cNvGraphicFramePr>
              <a:graphicFrameLocks noChangeAspect="1"/>
            </p:cNvGraphicFramePr>
            <p:nvPr/>
          </p:nvGraphicFramePr>
          <p:xfrm>
            <a:off x="2525713" y="1608138"/>
            <a:ext cx="2268537" cy="276225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10" r:id="rId2" imgW="2268495" imgH="2762742" progId="Prism10.Document">
                    <p:embed/>
                  </p:oleObj>
                </mc:Choice>
                <mc:Fallback>
                  <p:oleObj name="Prism 10" r:id="rId2" imgW="2268495" imgH="2762742" progId="Prism10.Document">
                    <p:embed/>
                    <p:pic>
                      <p:nvPicPr>
                        <p:cNvPr id="2" name="Object 1">
                          <a:extLst>
                            <a:ext uri="{FF2B5EF4-FFF2-40B4-BE49-F238E27FC236}">
                              <a16:creationId xmlns:a16="http://schemas.microsoft.com/office/drawing/2014/main" id="{57AD35D3-A46E-B9F9-763E-257E88888F5F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3"/>
                        <a:stretch>
                          <a:fillRect/>
                        </a:stretch>
                      </p:blipFill>
                      <p:spPr>
                        <a:xfrm>
                          <a:off x="2525713" y="1608138"/>
                          <a:ext cx="2268537" cy="276225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5" name="TextBox 4">
              <a:extLst>
                <a:ext uri="{FF2B5EF4-FFF2-40B4-BE49-F238E27FC236}">
                  <a16:creationId xmlns:a16="http://schemas.microsoft.com/office/drawing/2014/main" id="{CA59AFFB-1A8F-0950-58E7-76F2385B553B}"/>
                </a:ext>
              </a:extLst>
            </p:cNvPr>
            <p:cNvSpPr txBox="1"/>
            <p:nvPr/>
          </p:nvSpPr>
          <p:spPr>
            <a:xfrm>
              <a:off x="3202807" y="4017787"/>
              <a:ext cx="1523174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/>
                <a:t>PBS     </a:t>
              </a:r>
              <a:r>
                <a:rPr lang="en-US" sz="1200" err="1"/>
                <a:t>Bleo</a:t>
              </a:r>
              <a:r>
                <a:rPr lang="en-US" sz="1200"/>
                <a:t>   </a:t>
              </a:r>
              <a:r>
                <a:rPr lang="en-US" sz="1200" err="1"/>
                <a:t>Bleo</a:t>
              </a:r>
              <a:endParaRPr lang="en-US" sz="1200"/>
            </a:p>
            <a:p>
              <a:r>
                <a:rPr lang="en-US" sz="1200"/>
                <a:t>                       IL23ab</a:t>
              </a:r>
              <a:r>
                <a:rPr lang="en-US" sz="1200" baseline="30000"/>
                <a:t>hi</a:t>
              </a:r>
              <a:r>
                <a:rPr lang="en-US" sz="1200"/>
                <a:t> 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1650944412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>
            <a:extLst>
              <a:ext uri="{FF2B5EF4-FFF2-40B4-BE49-F238E27FC236}">
                <a16:creationId xmlns:a16="http://schemas.microsoft.com/office/drawing/2014/main" id="{439365F7-3810-C65F-79C5-5811C400020C}"/>
              </a:ext>
            </a:extLst>
          </p:cNvPr>
          <p:cNvGrpSpPr/>
          <p:nvPr/>
        </p:nvGrpSpPr>
        <p:grpSpPr>
          <a:xfrm>
            <a:off x="4251469" y="1651578"/>
            <a:ext cx="2325687" cy="3000082"/>
            <a:chOff x="880402" y="2074472"/>
            <a:chExt cx="2325687" cy="3000082"/>
          </a:xfrm>
        </p:grpSpPr>
        <p:graphicFrame>
          <p:nvGraphicFramePr>
            <p:cNvPr id="3" name="Object 2">
              <a:extLst>
                <a:ext uri="{FF2B5EF4-FFF2-40B4-BE49-F238E27FC236}">
                  <a16:creationId xmlns:a16="http://schemas.microsoft.com/office/drawing/2014/main" id="{32B49E4D-8C17-6C79-2262-13D58F0971C9}"/>
                </a:ext>
              </a:extLst>
            </p:cNvPr>
            <p:cNvGraphicFramePr>
              <a:graphicFrameLocks noChangeAspect="1"/>
            </p:cNvGraphicFramePr>
            <p:nvPr/>
          </p:nvGraphicFramePr>
          <p:xfrm>
            <a:off x="880402" y="2074472"/>
            <a:ext cx="2325687" cy="287655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10" r:id="rId2" imgW="2325036" imgH="2876910" progId="Prism10.Document">
                    <p:embed/>
                  </p:oleObj>
                </mc:Choice>
                <mc:Fallback>
                  <p:oleObj name="Prism 10" r:id="rId2" imgW="2325036" imgH="2876910" progId="Prism10.Document">
                    <p:embed/>
                    <p:pic>
                      <p:nvPicPr>
                        <p:cNvPr id="3" name="Object 2">
                          <a:extLst>
                            <a:ext uri="{FF2B5EF4-FFF2-40B4-BE49-F238E27FC236}">
                              <a16:creationId xmlns:a16="http://schemas.microsoft.com/office/drawing/2014/main" id="{32B49E4D-8C17-6C79-2262-13D58F0971C9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3"/>
                        <a:stretch>
                          <a:fillRect/>
                        </a:stretch>
                      </p:blipFill>
                      <p:spPr>
                        <a:xfrm>
                          <a:off x="880402" y="2074472"/>
                          <a:ext cx="2325687" cy="287655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4" name="TextBox 3">
              <a:extLst>
                <a:ext uri="{FF2B5EF4-FFF2-40B4-BE49-F238E27FC236}">
                  <a16:creationId xmlns:a16="http://schemas.microsoft.com/office/drawing/2014/main" id="{D9CBBEA3-92AD-6148-D5E6-6613B049F47A}"/>
                </a:ext>
              </a:extLst>
            </p:cNvPr>
            <p:cNvSpPr txBox="1"/>
            <p:nvPr/>
          </p:nvSpPr>
          <p:spPr>
            <a:xfrm>
              <a:off x="1597913" y="4612889"/>
              <a:ext cx="1417376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/>
                <a:t>PBS   </a:t>
              </a:r>
              <a:r>
                <a:rPr lang="en-US" sz="1200" err="1"/>
                <a:t>Bleo</a:t>
              </a:r>
              <a:r>
                <a:rPr lang="en-US" sz="1200"/>
                <a:t>   </a:t>
              </a:r>
              <a:r>
                <a:rPr lang="en-US" sz="1200" err="1"/>
                <a:t>Bleo</a:t>
              </a:r>
              <a:endParaRPr lang="en-US" sz="1200"/>
            </a:p>
            <a:p>
              <a:r>
                <a:rPr lang="en-US" sz="1200"/>
                <a:t>                    IL23ab</a:t>
              </a:r>
              <a:r>
                <a:rPr lang="en-US" sz="1200" baseline="30000"/>
                <a:t>hi</a:t>
              </a:r>
              <a:r>
                <a:rPr lang="en-US" sz="1200"/>
                <a:t> </a:t>
              </a:r>
            </a:p>
          </p:txBody>
        </p:sp>
      </p:grpSp>
      <p:sp>
        <p:nvSpPr>
          <p:cNvPr id="5" name="TextBox 4">
            <a:extLst>
              <a:ext uri="{FF2B5EF4-FFF2-40B4-BE49-F238E27FC236}">
                <a16:creationId xmlns:a16="http://schemas.microsoft.com/office/drawing/2014/main" id="{09A99FA2-E6F8-11F1-ADD4-CE416DBA7AAC}"/>
              </a:ext>
            </a:extLst>
          </p:cNvPr>
          <p:cNvSpPr txBox="1"/>
          <p:nvPr/>
        </p:nvSpPr>
        <p:spPr>
          <a:xfrm>
            <a:off x="259729" y="241498"/>
            <a:ext cx="3817584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800"/>
              <a:t>Supplementary Figure S5</a:t>
            </a:r>
          </a:p>
        </p:txBody>
      </p:sp>
    </p:spTree>
    <p:extLst>
      <p:ext uri="{BB962C8B-B14F-4D97-AF65-F5344CB8AC3E}">
        <p14:creationId xmlns:p14="http://schemas.microsoft.com/office/powerpoint/2010/main" val="65838217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81</Words>
  <Application>Microsoft Office PowerPoint</Application>
  <PresentationFormat>Widescreen</PresentationFormat>
  <Paragraphs>33</Paragraphs>
  <Slides>5</Slides>
  <Notes>1</Notes>
  <HiddenSlides>0</HiddenSlides>
  <MMClips>0</MMClips>
  <ScaleCrop>false</ScaleCrop>
  <HeadingPairs>
    <vt:vector size="8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11" baseType="lpstr">
      <vt:lpstr>Aptos</vt:lpstr>
      <vt:lpstr>Aptos Display</vt:lpstr>
      <vt:lpstr>Arial</vt:lpstr>
      <vt:lpstr>Calibri</vt:lpstr>
      <vt:lpstr>Office Theme</vt:lpstr>
      <vt:lpstr>Prism 10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Michigan Medicine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Verma, Priyanka</dc:creator>
  <cp:lastModifiedBy>Verma, Priyanka</cp:lastModifiedBy>
  <cp:revision>1</cp:revision>
  <dcterms:created xsi:type="dcterms:W3CDTF">2026-01-26T20:02:21Z</dcterms:created>
  <dcterms:modified xsi:type="dcterms:W3CDTF">2026-01-26T20:02:30Z</dcterms:modified>
</cp:coreProperties>
</file>